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10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27" autoAdjust="0"/>
    <p:restoredTop sz="91212" autoAdjust="0"/>
  </p:normalViewPr>
  <p:slideViewPr>
    <p:cSldViewPr snapToGrid="0" showGuides="1">
      <p:cViewPr>
        <p:scale>
          <a:sx n="125" d="100"/>
          <a:sy n="125" d="100"/>
        </p:scale>
        <p:origin x="1340" y="336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vi\Dropbox\EMT-PCR\shPPARD\SUMMARY%20%20shPPARD%20PCR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Javi\Dropbox\EMT-PCR\shPPARD\SUMMARY%20%20shPPARD%20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avi\Dropbox\EMT-PCR\shPPARD\SUMMARY%20%20shPPARD%20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697102666092703E-2"/>
          <c:y val="0.20402823744309401"/>
          <c:w val="0.92803881539732602"/>
          <c:h val="0.74116501030225701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EMT 253'!$B$20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253'!$Q$21:$Q$36</c:f>
                <c:numCache>
                  <c:formatCode>General</c:formatCode>
                  <c:ptCount val="16"/>
                  <c:pt idx="0">
                    <c:v>3.5740955494358198E-2</c:v>
                  </c:pt>
                  <c:pt idx="1">
                    <c:v>2.2146653210150111</c:v>
                  </c:pt>
                  <c:pt idx="2">
                    <c:v>0.97599804939699897</c:v>
                  </c:pt>
                  <c:pt idx="3">
                    <c:v>3.6722413042135171</c:v>
                  </c:pt>
                  <c:pt idx="4">
                    <c:v>0.17926922069277901</c:v>
                  </c:pt>
                  <c:pt idx="5">
                    <c:v>0.43492656266101498</c:v>
                  </c:pt>
                  <c:pt idx="6">
                    <c:v>0.289086211196529</c:v>
                  </c:pt>
                  <c:pt idx="7">
                    <c:v>0.46805406008600298</c:v>
                  </c:pt>
                  <c:pt idx="8">
                    <c:v>0.205925839162867</c:v>
                  </c:pt>
                  <c:pt idx="9">
                    <c:v>0.498634364353848</c:v>
                  </c:pt>
                  <c:pt idx="10">
                    <c:v>0.133661471690916</c:v>
                  </c:pt>
                  <c:pt idx="11">
                    <c:v>0.131296798291624</c:v>
                  </c:pt>
                  <c:pt idx="12">
                    <c:v>0.176981631985306</c:v>
                  </c:pt>
                  <c:pt idx="13">
                    <c:v>0.59430442828809005</c:v>
                  </c:pt>
                  <c:pt idx="14">
                    <c:v>0.138915119589227</c:v>
                  </c:pt>
                  <c:pt idx="15">
                    <c:v>0.193673953949677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253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253'!$O$21:$O$36</c:f>
              <c:numCache>
                <c:formatCode>General</c:formatCode>
                <c:ptCount val="16"/>
                <c:pt idx="0">
                  <c:v>1.002313664185245</c:v>
                </c:pt>
                <c:pt idx="1">
                  <c:v>4.0946943594510046</c:v>
                </c:pt>
                <c:pt idx="2">
                  <c:v>2.6019973111654342</c:v>
                </c:pt>
                <c:pt idx="3">
                  <c:v>5.4541822868208856</c:v>
                </c:pt>
                <c:pt idx="4">
                  <c:v>0.938283371785544</c:v>
                </c:pt>
                <c:pt idx="5">
                  <c:v>1.099525716526107</c:v>
                </c:pt>
                <c:pt idx="6">
                  <c:v>0.89086251080766599</c:v>
                </c:pt>
                <c:pt idx="7">
                  <c:v>1.2389059036201351</c:v>
                </c:pt>
                <c:pt idx="8">
                  <c:v>0.81161575689139098</c:v>
                </c:pt>
                <c:pt idx="9">
                  <c:v>1.3779354611398129</c:v>
                </c:pt>
                <c:pt idx="10">
                  <c:v>0.70383154938522996</c:v>
                </c:pt>
                <c:pt idx="11">
                  <c:v>0.795939632085372</c:v>
                </c:pt>
                <c:pt idx="12">
                  <c:v>0.93647860286435303</c:v>
                </c:pt>
                <c:pt idx="13">
                  <c:v>1.74252106580096</c:v>
                </c:pt>
                <c:pt idx="14">
                  <c:v>1.1555536198152221</c:v>
                </c:pt>
                <c:pt idx="15">
                  <c:v>1.0854963656790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3BC-734F-B761-845345C0C3CD}"/>
            </c:ext>
          </c:extLst>
        </c:ser>
        <c:ser>
          <c:idx val="5"/>
          <c:order val="1"/>
          <c:tx>
            <c:strRef>
              <c:f>'EMT 253'!$B$92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253'!$Q$93:$Q$108</c:f>
                <c:numCache>
                  <c:formatCode>General</c:formatCode>
                  <c:ptCount val="16"/>
                  <c:pt idx="0">
                    <c:v>8.4558656033024204E-2</c:v>
                  </c:pt>
                  <c:pt idx="1">
                    <c:v>0.37310713896983999</c:v>
                  </c:pt>
                  <c:pt idx="2">
                    <c:v>0.44001842991184797</c:v>
                  </c:pt>
                  <c:pt idx="3">
                    <c:v>3.7185474011850022</c:v>
                  </c:pt>
                  <c:pt idx="4">
                    <c:v>8.1977326542023499E-2</c:v>
                  </c:pt>
                  <c:pt idx="5">
                    <c:v>0.16518004207001599</c:v>
                  </c:pt>
                  <c:pt idx="6">
                    <c:v>8.4913941006927701E-2</c:v>
                  </c:pt>
                  <c:pt idx="7">
                    <c:v>0.52657296073578697</c:v>
                  </c:pt>
                  <c:pt idx="8">
                    <c:v>9.0356270813455403E-2</c:v>
                  </c:pt>
                  <c:pt idx="9">
                    <c:v>0.317709301279548</c:v>
                  </c:pt>
                  <c:pt idx="10">
                    <c:v>0.13690258693084001</c:v>
                  </c:pt>
                  <c:pt idx="11">
                    <c:v>0.86733922449026701</c:v>
                  </c:pt>
                  <c:pt idx="12">
                    <c:v>0.17317855163034701</c:v>
                  </c:pt>
                  <c:pt idx="13">
                    <c:v>0.225884747666311</c:v>
                  </c:pt>
                  <c:pt idx="14">
                    <c:v>0.18588145844169399</c:v>
                  </c:pt>
                  <c:pt idx="15">
                    <c:v>2.2458315422389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53'!$O$93:$O$108</c:f>
              <c:numCache>
                <c:formatCode>General</c:formatCode>
                <c:ptCount val="16"/>
                <c:pt idx="0">
                  <c:v>1.014107135686602</c:v>
                </c:pt>
                <c:pt idx="1">
                  <c:v>2.1318104916994138</c:v>
                </c:pt>
                <c:pt idx="2">
                  <c:v>1.6961488250077159</c:v>
                </c:pt>
                <c:pt idx="3">
                  <c:v>7.8476754170890386</c:v>
                </c:pt>
                <c:pt idx="4">
                  <c:v>1.013345071146257</c:v>
                </c:pt>
                <c:pt idx="5">
                  <c:v>0.70617849134168897</c:v>
                </c:pt>
                <c:pt idx="6">
                  <c:v>0.761347772826241</c:v>
                </c:pt>
                <c:pt idx="7">
                  <c:v>1.5105784205818711</c:v>
                </c:pt>
                <c:pt idx="8">
                  <c:v>1.01289785793655</c:v>
                </c:pt>
                <c:pt idx="9">
                  <c:v>1.529831268835244</c:v>
                </c:pt>
                <c:pt idx="10">
                  <c:v>1.0450887016508881</c:v>
                </c:pt>
                <c:pt idx="11">
                  <c:v>2.4345165671223081</c:v>
                </c:pt>
                <c:pt idx="12">
                  <c:v>1.141877067039097</c:v>
                </c:pt>
                <c:pt idx="13">
                  <c:v>0.72770136089881798</c:v>
                </c:pt>
                <c:pt idx="14">
                  <c:v>0.60810632128490705</c:v>
                </c:pt>
                <c:pt idx="15">
                  <c:v>3.4211054773146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3BC-734F-B761-845345C0C3CD}"/>
            </c:ext>
          </c:extLst>
        </c:ser>
        <c:ser>
          <c:idx val="4"/>
          <c:order val="2"/>
          <c:tx>
            <c:strRef>
              <c:f>'EMT 253'!$B$74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253'!$Q$75:$Q$90</c:f>
                <c:numCache>
                  <c:formatCode>General</c:formatCode>
                  <c:ptCount val="16"/>
                  <c:pt idx="0">
                    <c:v>9.2845979864137104E-2</c:v>
                  </c:pt>
                  <c:pt idx="1">
                    <c:v>0.47153257024830197</c:v>
                  </c:pt>
                  <c:pt idx="2">
                    <c:v>0.59225132561053595</c:v>
                  </c:pt>
                  <c:pt idx="3">
                    <c:v>4.0976403335478064</c:v>
                  </c:pt>
                  <c:pt idx="4">
                    <c:v>0.16866657877410601</c:v>
                  </c:pt>
                  <c:pt idx="5">
                    <c:v>0.109513883495928</c:v>
                  </c:pt>
                  <c:pt idx="6">
                    <c:v>0.19036343490476201</c:v>
                  </c:pt>
                  <c:pt idx="7">
                    <c:v>0.25601479582321202</c:v>
                  </c:pt>
                  <c:pt idx="8">
                    <c:v>0.138579796314305</c:v>
                  </c:pt>
                  <c:pt idx="9">
                    <c:v>0.343280848769492</c:v>
                  </c:pt>
                  <c:pt idx="10">
                    <c:v>0.33223025735619099</c:v>
                  </c:pt>
                  <c:pt idx="11">
                    <c:v>0.53664038142675297</c:v>
                  </c:pt>
                  <c:pt idx="12">
                    <c:v>0.131765529219493</c:v>
                  </c:pt>
                  <c:pt idx="13">
                    <c:v>0.223907217322695</c:v>
                  </c:pt>
                  <c:pt idx="14">
                    <c:v>0.25121109900962402</c:v>
                  </c:pt>
                  <c:pt idx="15">
                    <c:v>0.69488342133483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53'!$O$75:$O$90</c:f>
              <c:numCache>
                <c:formatCode>General</c:formatCode>
                <c:ptCount val="16"/>
                <c:pt idx="0">
                  <c:v>1.0169593566852611</c:v>
                </c:pt>
                <c:pt idx="1">
                  <c:v>2.4447452895723241</c:v>
                </c:pt>
                <c:pt idx="2">
                  <c:v>2.087202539826424</c:v>
                </c:pt>
                <c:pt idx="3">
                  <c:v>6.8615584066383946</c:v>
                </c:pt>
                <c:pt idx="4">
                  <c:v>1.044049953716873</c:v>
                </c:pt>
                <c:pt idx="5">
                  <c:v>1.2098845684199511</c:v>
                </c:pt>
                <c:pt idx="6">
                  <c:v>1.1063252303879121</c:v>
                </c:pt>
                <c:pt idx="7">
                  <c:v>1.123334175765379</c:v>
                </c:pt>
                <c:pt idx="8">
                  <c:v>1.038130754340636</c:v>
                </c:pt>
                <c:pt idx="9">
                  <c:v>1.2841655023194201</c:v>
                </c:pt>
                <c:pt idx="10">
                  <c:v>1.3558300621431529</c:v>
                </c:pt>
                <c:pt idx="11">
                  <c:v>1.861997147313732</c:v>
                </c:pt>
                <c:pt idx="12">
                  <c:v>1.027050361412547</c:v>
                </c:pt>
                <c:pt idx="13">
                  <c:v>1.094376275662603</c:v>
                </c:pt>
                <c:pt idx="14">
                  <c:v>1.208608709238884</c:v>
                </c:pt>
                <c:pt idx="15">
                  <c:v>1.7124719148157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3BC-734F-B761-845345C0C3CD}"/>
            </c:ext>
          </c:extLst>
        </c:ser>
        <c:ser>
          <c:idx val="1"/>
          <c:order val="3"/>
          <c:tx>
            <c:strRef>
              <c:f>'EMT 253'!$B$2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253'!$Q$3:$Q$18</c:f>
                <c:numCache>
                  <c:formatCode>General</c:formatCode>
                  <c:ptCount val="16"/>
                  <c:pt idx="0">
                    <c:v>0.16712460688346301</c:v>
                  </c:pt>
                  <c:pt idx="1">
                    <c:v>1.719875996950778</c:v>
                  </c:pt>
                  <c:pt idx="2">
                    <c:v>1.0899337794813011</c:v>
                  </c:pt>
                  <c:pt idx="3">
                    <c:v>6.3443794755165772</c:v>
                  </c:pt>
                  <c:pt idx="4">
                    <c:v>0.197692795555968</c:v>
                  </c:pt>
                  <c:pt idx="5">
                    <c:v>0.59132631968642402</c:v>
                  </c:pt>
                  <c:pt idx="6">
                    <c:v>0.283579755199103</c:v>
                  </c:pt>
                  <c:pt idx="7">
                    <c:v>1.2290251256859639</c:v>
                  </c:pt>
                  <c:pt idx="8">
                    <c:v>0.100954964039061</c:v>
                  </c:pt>
                  <c:pt idx="9">
                    <c:v>0.48088618622725299</c:v>
                  </c:pt>
                  <c:pt idx="10">
                    <c:v>0.37988915406914697</c:v>
                  </c:pt>
                  <c:pt idx="11">
                    <c:v>0.24603172308528001</c:v>
                  </c:pt>
                  <c:pt idx="12">
                    <c:v>0.10934943495713099</c:v>
                  </c:pt>
                  <c:pt idx="13">
                    <c:v>0.42094800771801999</c:v>
                  </c:pt>
                  <c:pt idx="14">
                    <c:v>0.28395892341524598</c:v>
                  </c:pt>
                  <c:pt idx="15">
                    <c:v>0.420403991911359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253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253'!$O$3:$O$18</c:f>
              <c:numCache>
                <c:formatCode>General</c:formatCode>
                <c:ptCount val="16"/>
                <c:pt idx="0">
                  <c:v>1.052428486472947</c:v>
                </c:pt>
                <c:pt idx="1">
                  <c:v>6.0692362563835056</c:v>
                </c:pt>
                <c:pt idx="2">
                  <c:v>3.1201069204109921</c:v>
                </c:pt>
                <c:pt idx="3">
                  <c:v>13.9223081714059</c:v>
                </c:pt>
                <c:pt idx="4">
                  <c:v>1.062473046111055</c:v>
                </c:pt>
                <c:pt idx="5">
                  <c:v>1.464851437388238</c:v>
                </c:pt>
                <c:pt idx="6">
                  <c:v>0.93282254929677799</c:v>
                </c:pt>
                <c:pt idx="7">
                  <c:v>2.4961765268009972</c:v>
                </c:pt>
                <c:pt idx="8">
                  <c:v>1.01787346650445</c:v>
                </c:pt>
                <c:pt idx="9">
                  <c:v>2.3730177209005001</c:v>
                </c:pt>
                <c:pt idx="10">
                  <c:v>1.350694181868443</c:v>
                </c:pt>
                <c:pt idx="11">
                  <c:v>1.74710386877169</c:v>
                </c:pt>
                <c:pt idx="12">
                  <c:v>1.0238857241792101</c:v>
                </c:pt>
                <c:pt idx="13">
                  <c:v>1.419394631619</c:v>
                </c:pt>
                <c:pt idx="14">
                  <c:v>1.7594038068728399</c:v>
                </c:pt>
                <c:pt idx="15">
                  <c:v>1.459091939308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3BC-734F-B761-845345C0C3CD}"/>
            </c:ext>
          </c:extLst>
        </c:ser>
        <c:ser>
          <c:idx val="0"/>
          <c:order val="4"/>
          <c:tx>
            <c:strRef>
              <c:f>'EMT 253'!$B$56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253'!$Q$57:$Q$72</c:f>
                <c:numCache>
                  <c:formatCode>General</c:formatCode>
                  <c:ptCount val="16"/>
                  <c:pt idx="0">
                    <c:v>5.8446981707307999E-2</c:v>
                  </c:pt>
                  <c:pt idx="1">
                    <c:v>0.73462283241399196</c:v>
                  </c:pt>
                  <c:pt idx="2">
                    <c:v>0.309439494338481</c:v>
                  </c:pt>
                  <c:pt idx="3">
                    <c:v>1.892544732233852</c:v>
                  </c:pt>
                  <c:pt idx="4">
                    <c:v>0.12057970037214299</c:v>
                  </c:pt>
                  <c:pt idx="5">
                    <c:v>0.309437964132107</c:v>
                  </c:pt>
                  <c:pt idx="6">
                    <c:v>0.12409720469671499</c:v>
                  </c:pt>
                  <c:pt idx="7">
                    <c:v>0.451567649177677</c:v>
                  </c:pt>
                  <c:pt idx="8">
                    <c:v>0.15150568323143501</c:v>
                  </c:pt>
                  <c:pt idx="9">
                    <c:v>0.53396012485449196</c:v>
                  </c:pt>
                  <c:pt idx="10">
                    <c:v>0.24694408546611399</c:v>
                  </c:pt>
                  <c:pt idx="11">
                    <c:v>0.30491607737941601</c:v>
                  </c:pt>
                  <c:pt idx="12">
                    <c:v>0.117407793711227</c:v>
                  </c:pt>
                  <c:pt idx="13">
                    <c:v>0.52369283068466499</c:v>
                  </c:pt>
                  <c:pt idx="14">
                    <c:v>0.22740230139456499</c:v>
                  </c:pt>
                  <c:pt idx="15">
                    <c:v>1.2079683684346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53'!$O$57:$O$72</c:f>
              <c:numCache>
                <c:formatCode>General</c:formatCode>
                <c:ptCount val="16"/>
                <c:pt idx="0">
                  <c:v>1.0058901804759821</c:v>
                </c:pt>
                <c:pt idx="1">
                  <c:v>2.854005082352753</c:v>
                </c:pt>
                <c:pt idx="2">
                  <c:v>2.134951099463152</c:v>
                </c:pt>
                <c:pt idx="3">
                  <c:v>6.5186501630029463</c:v>
                </c:pt>
                <c:pt idx="4">
                  <c:v>1.0271541839646481</c:v>
                </c:pt>
                <c:pt idx="5">
                  <c:v>1.1467503778596799</c:v>
                </c:pt>
                <c:pt idx="6">
                  <c:v>0.92404585475565604</c:v>
                </c:pt>
                <c:pt idx="7">
                  <c:v>1.2703437002957381</c:v>
                </c:pt>
                <c:pt idx="8">
                  <c:v>1.0386919946317801</c:v>
                </c:pt>
                <c:pt idx="9">
                  <c:v>1.5581509063053629</c:v>
                </c:pt>
                <c:pt idx="10">
                  <c:v>1.0390789456803211</c:v>
                </c:pt>
                <c:pt idx="11">
                  <c:v>1.5029648549607539</c:v>
                </c:pt>
                <c:pt idx="12">
                  <c:v>1.0263769659936459</c:v>
                </c:pt>
                <c:pt idx="13">
                  <c:v>1.81215932150926</c:v>
                </c:pt>
                <c:pt idx="14">
                  <c:v>1.11643492720389</c:v>
                </c:pt>
                <c:pt idx="15">
                  <c:v>2.45611460162579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3BC-734F-B761-845345C0C3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602000"/>
        <c:axId val="285602560"/>
      </c:barChart>
      <c:catAx>
        <c:axId val="285602000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285602560"/>
        <c:crosses val="autoZero"/>
        <c:auto val="1"/>
        <c:lblAlgn val="ctr"/>
        <c:lblOffset val="100"/>
        <c:noMultiLvlLbl val="0"/>
      </c:catAx>
      <c:valAx>
        <c:axId val="28560256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85602000"/>
        <c:crosses val="autoZero"/>
        <c:crossBetween val="between"/>
      </c:valAx>
      <c:spPr>
        <a:solidFill>
          <a:schemeClr val="bg1"/>
        </a:solidFill>
        <a:ln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3.9919721290817098E-2"/>
          <c:y val="0.134349816222882"/>
          <c:w val="0.95042188910495595"/>
          <c:h val="0.81578900319936598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EMT 354'!$B$20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354'!$AD$21:$AD$36</c:f>
                <c:numCache>
                  <c:formatCode>General</c:formatCode>
                  <c:ptCount val="16"/>
                  <c:pt idx="0">
                    <c:v>6.1845363025213103E-2</c:v>
                  </c:pt>
                  <c:pt idx="1">
                    <c:v>0.18017979502431899</c:v>
                  </c:pt>
                  <c:pt idx="2">
                    <c:v>0.29381270091693401</c:v>
                  </c:pt>
                  <c:pt idx="3">
                    <c:v>0.15776186004475201</c:v>
                  </c:pt>
                  <c:pt idx="4">
                    <c:v>6.2967118632639901E-2</c:v>
                  </c:pt>
                  <c:pt idx="5">
                    <c:v>0.14885012868353301</c:v>
                  </c:pt>
                  <c:pt idx="6">
                    <c:v>0.122313780398043</c:v>
                  </c:pt>
                  <c:pt idx="7">
                    <c:v>0.14619625221532501</c:v>
                  </c:pt>
                  <c:pt idx="8">
                    <c:v>5.9229641191177698E-2</c:v>
                  </c:pt>
                  <c:pt idx="9">
                    <c:v>0.17833064356707401</c:v>
                  </c:pt>
                  <c:pt idx="10">
                    <c:v>0.14052311538192699</c:v>
                  </c:pt>
                  <c:pt idx="11">
                    <c:v>7.2281009989580106E-2</c:v>
                  </c:pt>
                  <c:pt idx="12">
                    <c:v>4.3595253977995997E-2</c:v>
                  </c:pt>
                  <c:pt idx="13">
                    <c:v>0.184211170348835</c:v>
                  </c:pt>
                  <c:pt idx="14">
                    <c:v>0.13019921205621399</c:v>
                  </c:pt>
                  <c:pt idx="15">
                    <c:v>0.1544921123578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354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354'!$AB$21:$AB$36</c:f>
              <c:numCache>
                <c:formatCode>General</c:formatCode>
                <c:ptCount val="16"/>
                <c:pt idx="0">
                  <c:v>1.013574703577178</c:v>
                </c:pt>
                <c:pt idx="1">
                  <c:v>1.518643255489438</c:v>
                </c:pt>
                <c:pt idx="2">
                  <c:v>1.7722923043542329</c:v>
                </c:pt>
                <c:pt idx="3">
                  <c:v>1.6702173999042469</c:v>
                </c:pt>
                <c:pt idx="4">
                  <c:v>1.015306926352902</c:v>
                </c:pt>
                <c:pt idx="5">
                  <c:v>0.95372854804633</c:v>
                </c:pt>
                <c:pt idx="6">
                  <c:v>0.99949499641390405</c:v>
                </c:pt>
                <c:pt idx="7">
                  <c:v>1.000630458663494</c:v>
                </c:pt>
                <c:pt idx="8">
                  <c:v>1.013801107216016</c:v>
                </c:pt>
                <c:pt idx="9">
                  <c:v>0.95308104694751705</c:v>
                </c:pt>
                <c:pt idx="10">
                  <c:v>1.134034793118837</c:v>
                </c:pt>
                <c:pt idx="11">
                  <c:v>0.87682612964996398</c:v>
                </c:pt>
                <c:pt idx="12">
                  <c:v>1.008160631595767</c:v>
                </c:pt>
                <c:pt idx="13">
                  <c:v>1.0671164833539331</c:v>
                </c:pt>
                <c:pt idx="14">
                  <c:v>1.08056165319909</c:v>
                </c:pt>
                <c:pt idx="15">
                  <c:v>1.1476308448250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DD-0948-B003-E9AA0469DBDE}"/>
            </c:ext>
          </c:extLst>
        </c:ser>
        <c:ser>
          <c:idx val="0"/>
          <c:order val="1"/>
          <c:tx>
            <c:strRef>
              <c:f>'EMT 354'!$B$56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354'!$AD$57:$AD$72</c:f>
                <c:numCache>
                  <c:formatCode>General</c:formatCode>
                  <c:ptCount val="16"/>
                  <c:pt idx="0">
                    <c:v>7.5502517401007996E-2</c:v>
                  </c:pt>
                  <c:pt idx="1">
                    <c:v>0.64500085206347302</c:v>
                  </c:pt>
                  <c:pt idx="2">
                    <c:v>0.63000559961400904</c:v>
                  </c:pt>
                  <c:pt idx="3">
                    <c:v>0.47436985402985399</c:v>
                  </c:pt>
                  <c:pt idx="4">
                    <c:v>9.15217746372185E-2</c:v>
                  </c:pt>
                  <c:pt idx="5">
                    <c:v>0.191416128805243</c:v>
                  </c:pt>
                  <c:pt idx="6">
                    <c:v>0.52019563928190005</c:v>
                  </c:pt>
                  <c:pt idx="7">
                    <c:v>0.477254840727309</c:v>
                  </c:pt>
                  <c:pt idx="8">
                    <c:v>7.1379820839385905E-2</c:v>
                  </c:pt>
                  <c:pt idx="9">
                    <c:v>0.18234273608217499</c:v>
                  </c:pt>
                  <c:pt idx="10">
                    <c:v>0.26471958346430402</c:v>
                  </c:pt>
                  <c:pt idx="11">
                    <c:v>0.40314906179708798</c:v>
                  </c:pt>
                  <c:pt idx="12">
                    <c:v>0.13601114906711401</c:v>
                  </c:pt>
                  <c:pt idx="13">
                    <c:v>0.31542891214430802</c:v>
                  </c:pt>
                  <c:pt idx="14">
                    <c:v>0.23917055040319399</c:v>
                  </c:pt>
                  <c:pt idx="15">
                    <c:v>0.414620660711455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354'!$AB$57:$AB$72</c:f>
              <c:numCache>
                <c:formatCode>General</c:formatCode>
                <c:ptCount val="16"/>
                <c:pt idx="0">
                  <c:v>1.0348653534505801</c:v>
                </c:pt>
                <c:pt idx="1">
                  <c:v>2.9968887320239461</c:v>
                </c:pt>
                <c:pt idx="2">
                  <c:v>2.824825705413049</c:v>
                </c:pt>
                <c:pt idx="3">
                  <c:v>3.2050847517635579</c:v>
                </c:pt>
                <c:pt idx="4">
                  <c:v>1.041967376722424</c:v>
                </c:pt>
                <c:pt idx="5">
                  <c:v>1.392184731260333</c:v>
                </c:pt>
                <c:pt idx="6">
                  <c:v>2.026036534115057</c:v>
                </c:pt>
                <c:pt idx="7">
                  <c:v>2.22405661260313</c:v>
                </c:pt>
                <c:pt idx="8">
                  <c:v>1.016647424957865</c:v>
                </c:pt>
                <c:pt idx="9">
                  <c:v>1.3594249281697</c:v>
                </c:pt>
                <c:pt idx="10">
                  <c:v>1.205701697122767</c:v>
                </c:pt>
                <c:pt idx="11">
                  <c:v>1.7989716473175701</c:v>
                </c:pt>
                <c:pt idx="12">
                  <c:v>1.054909498009978</c:v>
                </c:pt>
                <c:pt idx="13">
                  <c:v>2.196895170447124</c:v>
                </c:pt>
                <c:pt idx="14">
                  <c:v>1.554838212955336</c:v>
                </c:pt>
                <c:pt idx="15">
                  <c:v>2.08755285895059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FDD-0948-B003-E9AA0469DBDE}"/>
            </c:ext>
          </c:extLst>
        </c:ser>
        <c:ser>
          <c:idx val="4"/>
          <c:order val="2"/>
          <c:tx>
            <c:strRef>
              <c:f>'EMT 354'!$B$74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354'!$AD$75:$AD$90</c:f>
                <c:numCache>
                  <c:formatCode>General</c:formatCode>
                  <c:ptCount val="16"/>
                  <c:pt idx="0">
                    <c:v>5.4429077958131802E-2</c:v>
                  </c:pt>
                  <c:pt idx="1">
                    <c:v>2.3535972749250771</c:v>
                  </c:pt>
                  <c:pt idx="2">
                    <c:v>0.62187661855091803</c:v>
                  </c:pt>
                  <c:pt idx="3">
                    <c:v>0.52673326113913699</c:v>
                  </c:pt>
                  <c:pt idx="4">
                    <c:v>0.127260029087742</c:v>
                  </c:pt>
                  <c:pt idx="5">
                    <c:v>0.33964072392387001</c:v>
                  </c:pt>
                  <c:pt idx="6">
                    <c:v>0.59881187657191803</c:v>
                  </c:pt>
                  <c:pt idx="7">
                    <c:v>7.8025488361598103E-2</c:v>
                  </c:pt>
                  <c:pt idx="8">
                    <c:v>0.123439940686445</c:v>
                  </c:pt>
                  <c:pt idx="9">
                    <c:v>0.43909217144050799</c:v>
                  </c:pt>
                  <c:pt idx="10">
                    <c:v>0.26554700403014603</c:v>
                  </c:pt>
                  <c:pt idx="11">
                    <c:v>0.21760899195726699</c:v>
                  </c:pt>
                  <c:pt idx="12">
                    <c:v>0.200023072697424</c:v>
                  </c:pt>
                  <c:pt idx="13">
                    <c:v>0.38756431189364599</c:v>
                  </c:pt>
                  <c:pt idx="14">
                    <c:v>0.39135682434825497</c:v>
                  </c:pt>
                  <c:pt idx="15">
                    <c:v>0.157999262497076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354'!$AB$75:$AB$90</c:f>
              <c:numCache>
                <c:formatCode>General</c:formatCode>
                <c:ptCount val="16"/>
                <c:pt idx="0">
                  <c:v>1.0244510597620751</c:v>
                </c:pt>
                <c:pt idx="1">
                  <c:v>4.3372683615395804</c:v>
                </c:pt>
                <c:pt idx="2">
                  <c:v>2.5587905753594282</c:v>
                </c:pt>
                <c:pt idx="3">
                  <c:v>2.8032295507070351</c:v>
                </c:pt>
                <c:pt idx="4">
                  <c:v>1.02324840499908</c:v>
                </c:pt>
                <c:pt idx="5">
                  <c:v>1.443321922383394</c:v>
                </c:pt>
                <c:pt idx="6">
                  <c:v>1.845088047243683</c:v>
                </c:pt>
                <c:pt idx="7">
                  <c:v>0.70634101147648698</c:v>
                </c:pt>
                <c:pt idx="8">
                  <c:v>1.0285005409675809</c:v>
                </c:pt>
                <c:pt idx="9">
                  <c:v>1.138985396525888</c:v>
                </c:pt>
                <c:pt idx="10">
                  <c:v>0.90176425859091203</c:v>
                </c:pt>
                <c:pt idx="11">
                  <c:v>0.83124008301195795</c:v>
                </c:pt>
                <c:pt idx="12">
                  <c:v>1.134732845186988</c:v>
                </c:pt>
                <c:pt idx="13">
                  <c:v>1.3353048909945251</c:v>
                </c:pt>
                <c:pt idx="14">
                  <c:v>1.79468261422652</c:v>
                </c:pt>
                <c:pt idx="15">
                  <c:v>0.72718134761734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FDD-0948-B003-E9AA0469DBDE}"/>
            </c:ext>
          </c:extLst>
        </c:ser>
        <c:ser>
          <c:idx val="1"/>
          <c:order val="3"/>
          <c:tx>
            <c:strRef>
              <c:f>'EMT 354'!$B$2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354'!$AD$3:$AD$18</c:f>
                <c:numCache>
                  <c:formatCode>General</c:formatCode>
                  <c:ptCount val="16"/>
                  <c:pt idx="0">
                    <c:v>3.9498177753817199E-2</c:v>
                  </c:pt>
                  <c:pt idx="1">
                    <c:v>0.73458217868088505</c:v>
                  </c:pt>
                  <c:pt idx="2">
                    <c:v>0.67643470555491003</c:v>
                  </c:pt>
                  <c:pt idx="3">
                    <c:v>0.13292132680791099</c:v>
                  </c:pt>
                  <c:pt idx="4">
                    <c:v>6.7744610291655294E-2</c:v>
                  </c:pt>
                  <c:pt idx="5">
                    <c:v>0.43017398183507999</c:v>
                  </c:pt>
                  <c:pt idx="6">
                    <c:v>0.22111572659755099</c:v>
                  </c:pt>
                  <c:pt idx="7">
                    <c:v>0.24824685861417201</c:v>
                  </c:pt>
                  <c:pt idx="8">
                    <c:v>5.8649905457277697E-2</c:v>
                  </c:pt>
                  <c:pt idx="9">
                    <c:v>0.30632947854249698</c:v>
                  </c:pt>
                  <c:pt idx="10">
                    <c:v>0.26178236617902001</c:v>
                  </c:pt>
                  <c:pt idx="11">
                    <c:v>0.23948016176026099</c:v>
                  </c:pt>
                  <c:pt idx="12">
                    <c:v>4.7125558494779202E-2</c:v>
                  </c:pt>
                  <c:pt idx="13">
                    <c:v>0.40390869528186701</c:v>
                  </c:pt>
                  <c:pt idx="14">
                    <c:v>0.24308032160162801</c:v>
                  </c:pt>
                  <c:pt idx="15">
                    <c:v>0.296550494964284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354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354'!$AB$3:$AB$18</c:f>
              <c:numCache>
                <c:formatCode>General</c:formatCode>
                <c:ptCount val="16"/>
                <c:pt idx="0">
                  <c:v>1.007102207435538</c:v>
                </c:pt>
                <c:pt idx="1">
                  <c:v>3.4675179761242472</c:v>
                </c:pt>
                <c:pt idx="2">
                  <c:v>2.6391718243410649</c:v>
                </c:pt>
                <c:pt idx="3">
                  <c:v>2.071978944391903</c:v>
                </c:pt>
                <c:pt idx="4">
                  <c:v>1.0191936614723449</c:v>
                </c:pt>
                <c:pt idx="5">
                  <c:v>1.500672385966338</c:v>
                </c:pt>
                <c:pt idx="6">
                  <c:v>1.5264398260123919</c:v>
                </c:pt>
                <c:pt idx="7">
                  <c:v>1.353228744479539</c:v>
                </c:pt>
                <c:pt idx="8">
                  <c:v>1.013803128648668</c:v>
                </c:pt>
                <c:pt idx="9">
                  <c:v>1.6429945912109709</c:v>
                </c:pt>
                <c:pt idx="10">
                  <c:v>1.4372471041471671</c:v>
                </c:pt>
                <c:pt idx="11">
                  <c:v>1.5865173390441301</c:v>
                </c:pt>
                <c:pt idx="12">
                  <c:v>1.009941006719127</c:v>
                </c:pt>
                <c:pt idx="13">
                  <c:v>2.4255410222496341</c:v>
                </c:pt>
                <c:pt idx="14">
                  <c:v>1.984947105986834</c:v>
                </c:pt>
                <c:pt idx="15">
                  <c:v>1.9708899902299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FDD-0948-B003-E9AA0469DBDE}"/>
            </c:ext>
          </c:extLst>
        </c:ser>
        <c:ser>
          <c:idx val="5"/>
          <c:order val="4"/>
          <c:tx>
            <c:strRef>
              <c:f>'EMT 354'!$B$92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354'!$AD$93:$AD$108</c:f>
                <c:numCache>
                  <c:formatCode>General</c:formatCode>
                  <c:ptCount val="16"/>
                  <c:pt idx="0">
                    <c:v>0.121218414377773</c:v>
                  </c:pt>
                  <c:pt idx="1">
                    <c:v>0.89359350490692602</c:v>
                  </c:pt>
                  <c:pt idx="2">
                    <c:v>1.0237301354506589</c:v>
                  </c:pt>
                  <c:pt idx="3">
                    <c:v>1.0138616306938</c:v>
                  </c:pt>
                  <c:pt idx="4">
                    <c:v>7.3847040224164398E-2</c:v>
                  </c:pt>
                  <c:pt idx="5">
                    <c:v>0.44348538749022798</c:v>
                  </c:pt>
                  <c:pt idx="6">
                    <c:v>0.43866029858806899</c:v>
                  </c:pt>
                  <c:pt idx="7">
                    <c:v>0.34180175393248302</c:v>
                  </c:pt>
                  <c:pt idx="8">
                    <c:v>7.6045144222515695E-2</c:v>
                  </c:pt>
                  <c:pt idx="9">
                    <c:v>0.82927237143567001</c:v>
                  </c:pt>
                  <c:pt idx="10">
                    <c:v>0.48350523885138402</c:v>
                  </c:pt>
                  <c:pt idx="11">
                    <c:v>0.53140886954913702</c:v>
                  </c:pt>
                  <c:pt idx="12">
                    <c:v>0.167378128476115</c:v>
                  </c:pt>
                  <c:pt idx="13">
                    <c:v>0.89241728896046102</c:v>
                  </c:pt>
                  <c:pt idx="14">
                    <c:v>0.53312973981005096</c:v>
                  </c:pt>
                  <c:pt idx="15">
                    <c:v>0.44502091351363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354'!$AB$93:$AB$108</c:f>
              <c:numCache>
                <c:formatCode>General</c:formatCode>
                <c:ptCount val="16"/>
                <c:pt idx="0">
                  <c:v>1.060564223751187</c:v>
                </c:pt>
                <c:pt idx="1">
                  <c:v>4.9721583480856699</c:v>
                </c:pt>
                <c:pt idx="2">
                  <c:v>4.1552603110396777</c:v>
                </c:pt>
                <c:pt idx="3">
                  <c:v>6.5630031738834669</c:v>
                </c:pt>
                <c:pt idx="4">
                  <c:v>1.019826672904169</c:v>
                </c:pt>
                <c:pt idx="5">
                  <c:v>2.0352557676202991</c:v>
                </c:pt>
                <c:pt idx="6">
                  <c:v>1.7577280295029321</c:v>
                </c:pt>
                <c:pt idx="7">
                  <c:v>1.808565460325406</c:v>
                </c:pt>
                <c:pt idx="8">
                  <c:v>0.970320723939607</c:v>
                </c:pt>
                <c:pt idx="9">
                  <c:v>2.7167322154678009</c:v>
                </c:pt>
                <c:pt idx="10">
                  <c:v>2.508300381799863</c:v>
                </c:pt>
                <c:pt idx="11">
                  <c:v>1.969101402826368</c:v>
                </c:pt>
                <c:pt idx="12">
                  <c:v>1.1039929460392399</c:v>
                </c:pt>
                <c:pt idx="13">
                  <c:v>3.3096532843519122</c:v>
                </c:pt>
                <c:pt idx="14">
                  <c:v>2.28795766629207</c:v>
                </c:pt>
                <c:pt idx="15">
                  <c:v>2.1228919554308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FDD-0948-B003-E9AA0469DB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607040"/>
        <c:axId val="285607600"/>
      </c:barChart>
      <c:catAx>
        <c:axId val="285607040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285607600"/>
        <c:crosses val="autoZero"/>
        <c:auto val="1"/>
        <c:lblAlgn val="ctr"/>
        <c:lblOffset val="100"/>
        <c:noMultiLvlLbl val="0"/>
      </c:catAx>
      <c:valAx>
        <c:axId val="2856076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85607040"/>
        <c:crosses val="autoZero"/>
        <c:crossBetween val="between"/>
        <c:majorUnit val="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5.1992216986096997E-2"/>
          <c:y val="5.3659175507755202E-2"/>
          <c:w val="0.94036912176446996"/>
          <c:h val="0.71236907372432701"/>
        </c:manualLayout>
      </c:layout>
      <c:barChart>
        <c:barDir val="col"/>
        <c:grouping val="clustered"/>
        <c:varyColors val="0"/>
        <c:ser>
          <c:idx val="2"/>
          <c:order val="0"/>
          <c:tx>
            <c:strRef>
              <c:f>'EMT 215'!$B$20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215'!$T$21:$T$36</c:f>
                <c:numCache>
                  <c:formatCode>General</c:formatCode>
                  <c:ptCount val="16"/>
                  <c:pt idx="0">
                    <c:v>0.127407872859129</c:v>
                  </c:pt>
                  <c:pt idx="1">
                    <c:v>1.4603552073120361</c:v>
                  </c:pt>
                  <c:pt idx="2">
                    <c:v>4.6588479069571447</c:v>
                  </c:pt>
                  <c:pt idx="3">
                    <c:v>1.2963842946903501</c:v>
                  </c:pt>
                  <c:pt idx="4">
                    <c:v>0.16068006237774299</c:v>
                  </c:pt>
                  <c:pt idx="5">
                    <c:v>0.96118548917303503</c:v>
                  </c:pt>
                  <c:pt idx="6">
                    <c:v>0.66430394597568099</c:v>
                  </c:pt>
                  <c:pt idx="7">
                    <c:v>0.211704736226655</c:v>
                  </c:pt>
                  <c:pt idx="8">
                    <c:v>0.110222968416331</c:v>
                  </c:pt>
                  <c:pt idx="9">
                    <c:v>0.531335041770024</c:v>
                  </c:pt>
                  <c:pt idx="10">
                    <c:v>0.241483242382144</c:v>
                  </c:pt>
                  <c:pt idx="11">
                    <c:v>0.169415909065155</c:v>
                  </c:pt>
                  <c:pt idx="12">
                    <c:v>4.47194637007126E-2</c:v>
                  </c:pt>
                  <c:pt idx="13">
                    <c:v>0.64546886994003705</c:v>
                  </c:pt>
                  <c:pt idx="14">
                    <c:v>0.152353355245372</c:v>
                  </c:pt>
                  <c:pt idx="15">
                    <c:v>0.209624715945165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215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215'!$R$21:$R$36</c:f>
              <c:numCache>
                <c:formatCode>General</c:formatCode>
                <c:ptCount val="16"/>
                <c:pt idx="0">
                  <c:v>1.0347495880335471</c:v>
                </c:pt>
                <c:pt idx="1">
                  <c:v>5.5334782098728148</c:v>
                </c:pt>
                <c:pt idx="2">
                  <c:v>7.7129769369282561</c:v>
                </c:pt>
                <c:pt idx="3">
                  <c:v>3.6554590845172541</c:v>
                </c:pt>
                <c:pt idx="4">
                  <c:v>1.05731036915601</c:v>
                </c:pt>
                <c:pt idx="5">
                  <c:v>2.5675553037886121</c:v>
                </c:pt>
                <c:pt idx="6">
                  <c:v>1.6944553881606781</c:v>
                </c:pt>
                <c:pt idx="7">
                  <c:v>1.04330399075711</c:v>
                </c:pt>
                <c:pt idx="8">
                  <c:v>1.0259908895819101</c:v>
                </c:pt>
                <c:pt idx="9">
                  <c:v>2.0455068245797472</c:v>
                </c:pt>
                <c:pt idx="10">
                  <c:v>1.1480359494177339</c:v>
                </c:pt>
                <c:pt idx="11">
                  <c:v>0.83994236978070502</c:v>
                </c:pt>
                <c:pt idx="12">
                  <c:v>1.004789407317668</c:v>
                </c:pt>
                <c:pt idx="13">
                  <c:v>2.3398529405223281</c:v>
                </c:pt>
                <c:pt idx="14">
                  <c:v>1.3485118600096671</c:v>
                </c:pt>
                <c:pt idx="15">
                  <c:v>1.04322467925646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B0F-0A4A-945E-B0F340D4C865}"/>
            </c:ext>
          </c:extLst>
        </c:ser>
        <c:ser>
          <c:idx val="3"/>
          <c:order val="1"/>
          <c:tx>
            <c:strRef>
              <c:f>'EMT 215'!$B$92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215'!$T$93:$T$108</c:f>
                <c:numCache>
                  <c:formatCode>General</c:formatCode>
                  <c:ptCount val="16"/>
                  <c:pt idx="0">
                    <c:v>9.8376151919085705E-2</c:v>
                  </c:pt>
                  <c:pt idx="1">
                    <c:v>0.235954410450887</c:v>
                  </c:pt>
                  <c:pt idx="2">
                    <c:v>1.286965134843115</c:v>
                  </c:pt>
                  <c:pt idx="3">
                    <c:v>1.1952085727578159</c:v>
                  </c:pt>
                  <c:pt idx="4">
                    <c:v>7.2906854124938095E-2</c:v>
                  </c:pt>
                  <c:pt idx="5">
                    <c:v>0.39511955284615702</c:v>
                  </c:pt>
                  <c:pt idx="6">
                    <c:v>0.41012613807517201</c:v>
                  </c:pt>
                  <c:pt idx="7">
                    <c:v>0.12008883309729</c:v>
                  </c:pt>
                  <c:pt idx="8">
                    <c:v>0.149404614095803</c:v>
                  </c:pt>
                  <c:pt idx="9">
                    <c:v>0.76414673637278097</c:v>
                  </c:pt>
                  <c:pt idx="10">
                    <c:v>0.55000226883526504</c:v>
                  </c:pt>
                  <c:pt idx="11">
                    <c:v>0.404357570594436</c:v>
                  </c:pt>
                  <c:pt idx="12">
                    <c:v>0.116500618874496</c:v>
                  </c:pt>
                  <c:pt idx="13">
                    <c:v>0.31644471361626397</c:v>
                  </c:pt>
                  <c:pt idx="14">
                    <c:v>0.229910800690487</c:v>
                  </c:pt>
                  <c:pt idx="15">
                    <c:v>0.114336362839468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15'!$R$93:$R$108</c:f>
              <c:numCache>
                <c:formatCode>General</c:formatCode>
                <c:ptCount val="16"/>
                <c:pt idx="0">
                  <c:v>1.02252639952032</c:v>
                </c:pt>
                <c:pt idx="1">
                  <c:v>1.713366303794692</c:v>
                </c:pt>
                <c:pt idx="2">
                  <c:v>3.9622771520112292</c:v>
                </c:pt>
                <c:pt idx="3">
                  <c:v>3.7988417922694762</c:v>
                </c:pt>
                <c:pt idx="4">
                  <c:v>1.011445513189535</c:v>
                </c:pt>
                <c:pt idx="5">
                  <c:v>1.6000029168327079</c:v>
                </c:pt>
                <c:pt idx="6">
                  <c:v>1.556988854886705</c:v>
                </c:pt>
                <c:pt idx="7">
                  <c:v>1.324780885094474</c:v>
                </c:pt>
                <c:pt idx="8">
                  <c:v>1.127089256855462</c:v>
                </c:pt>
                <c:pt idx="9">
                  <c:v>1.960263852434394</c:v>
                </c:pt>
                <c:pt idx="10">
                  <c:v>1.964970657090044</c:v>
                </c:pt>
                <c:pt idx="11">
                  <c:v>1.5825506803638849</c:v>
                </c:pt>
                <c:pt idx="12">
                  <c:v>1.0288809054422461</c:v>
                </c:pt>
                <c:pt idx="13">
                  <c:v>1.191038697940827</c:v>
                </c:pt>
                <c:pt idx="14">
                  <c:v>0.77982254443198196</c:v>
                </c:pt>
                <c:pt idx="15">
                  <c:v>0.790118849308745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B0F-0A4A-945E-B0F340D4C865}"/>
            </c:ext>
          </c:extLst>
        </c:ser>
        <c:ser>
          <c:idx val="4"/>
          <c:order val="2"/>
          <c:tx>
            <c:strRef>
              <c:f>'EMT 215'!$B$74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215'!$T$75:$T$90</c:f>
                <c:numCache>
                  <c:formatCode>General</c:formatCode>
                  <c:ptCount val="16"/>
                  <c:pt idx="0">
                    <c:v>0.18508622410329301</c:v>
                  </c:pt>
                  <c:pt idx="1">
                    <c:v>1.4968619595050301</c:v>
                  </c:pt>
                  <c:pt idx="2">
                    <c:v>1.194496396440877</c:v>
                  </c:pt>
                  <c:pt idx="3">
                    <c:v>2.4822554845379861</c:v>
                  </c:pt>
                  <c:pt idx="4">
                    <c:v>0.232212455963037</c:v>
                  </c:pt>
                  <c:pt idx="5">
                    <c:v>0.39907591169599599</c:v>
                  </c:pt>
                  <c:pt idx="6">
                    <c:v>0.460502728814005</c:v>
                  </c:pt>
                  <c:pt idx="7">
                    <c:v>0.48192993485524499</c:v>
                  </c:pt>
                  <c:pt idx="8">
                    <c:v>0.13205489850810201</c:v>
                  </c:pt>
                  <c:pt idx="9">
                    <c:v>0.55904507354980204</c:v>
                  </c:pt>
                  <c:pt idx="10">
                    <c:v>0.53686879822048605</c:v>
                  </c:pt>
                  <c:pt idx="11">
                    <c:v>0.52756763993093603</c:v>
                  </c:pt>
                  <c:pt idx="12">
                    <c:v>7.0074951673419303E-2</c:v>
                  </c:pt>
                  <c:pt idx="13">
                    <c:v>0.162100513346533</c:v>
                  </c:pt>
                  <c:pt idx="14">
                    <c:v>0.37402254939843399</c:v>
                  </c:pt>
                  <c:pt idx="15">
                    <c:v>0.717078029632751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15'!$R$75:$R$90</c:f>
              <c:numCache>
                <c:formatCode>General</c:formatCode>
                <c:ptCount val="16"/>
                <c:pt idx="0">
                  <c:v>1.064669912043573</c:v>
                </c:pt>
                <c:pt idx="1">
                  <c:v>4.8208672724708741</c:v>
                </c:pt>
                <c:pt idx="2">
                  <c:v>3.1707874084294132</c:v>
                </c:pt>
                <c:pt idx="3">
                  <c:v>5.6872986624558211</c:v>
                </c:pt>
                <c:pt idx="4">
                  <c:v>1.116857483844131</c:v>
                </c:pt>
                <c:pt idx="5">
                  <c:v>2.1126197509353521</c:v>
                </c:pt>
                <c:pt idx="6">
                  <c:v>1.301112303580225</c:v>
                </c:pt>
                <c:pt idx="7">
                  <c:v>1.4546840522863591</c:v>
                </c:pt>
                <c:pt idx="8">
                  <c:v>1.0356780229293019</c:v>
                </c:pt>
                <c:pt idx="9">
                  <c:v>2.5442994520949531</c:v>
                </c:pt>
                <c:pt idx="10">
                  <c:v>1.422337061421757</c:v>
                </c:pt>
                <c:pt idx="11">
                  <c:v>1.301170294531758</c:v>
                </c:pt>
                <c:pt idx="12">
                  <c:v>1.011450544403341</c:v>
                </c:pt>
                <c:pt idx="13">
                  <c:v>1.8321148161963909</c:v>
                </c:pt>
                <c:pt idx="14">
                  <c:v>1.476059784060203</c:v>
                </c:pt>
                <c:pt idx="15">
                  <c:v>2.2000618129448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B0F-0A4A-945E-B0F340D4C865}"/>
            </c:ext>
          </c:extLst>
        </c:ser>
        <c:ser>
          <c:idx val="1"/>
          <c:order val="3"/>
          <c:tx>
            <c:strRef>
              <c:f>'EMT 215'!$B$2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215'!$T$3:$T$18</c:f>
                <c:numCache>
                  <c:formatCode>General</c:formatCode>
                  <c:ptCount val="16"/>
                  <c:pt idx="0">
                    <c:v>8.35088535285963E-2</c:v>
                  </c:pt>
                  <c:pt idx="1">
                    <c:v>1.776345166121241</c:v>
                  </c:pt>
                  <c:pt idx="2">
                    <c:v>2.1872036175084828</c:v>
                  </c:pt>
                  <c:pt idx="3">
                    <c:v>0.57154661507458004</c:v>
                  </c:pt>
                  <c:pt idx="4">
                    <c:v>0.21542125830904099</c:v>
                  </c:pt>
                  <c:pt idx="5">
                    <c:v>1.126543674917033</c:v>
                  </c:pt>
                  <c:pt idx="6">
                    <c:v>0.52259677560614504</c:v>
                  </c:pt>
                  <c:pt idx="7">
                    <c:v>0.32565441380247201</c:v>
                  </c:pt>
                  <c:pt idx="8">
                    <c:v>0.12900138104699499</c:v>
                  </c:pt>
                  <c:pt idx="9">
                    <c:v>0.72664677085875695</c:v>
                  </c:pt>
                  <c:pt idx="10">
                    <c:v>0.58737772125115795</c:v>
                  </c:pt>
                  <c:pt idx="11">
                    <c:v>0.24417021923901999</c:v>
                  </c:pt>
                  <c:pt idx="12">
                    <c:v>0.10039367542944699</c:v>
                  </c:pt>
                  <c:pt idx="13">
                    <c:v>0.69495531847732706</c:v>
                  </c:pt>
                  <c:pt idx="14">
                    <c:v>0.27910762865077499</c:v>
                  </c:pt>
                  <c:pt idx="15">
                    <c:v>0.3494339591444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Metab 215'!$A$3:$B$18</c:f>
              <c:multiLvlStrCache>
                <c:ptCount val="16"/>
                <c:lvl>
                  <c:pt idx="0">
                    <c:v>Cont</c:v>
                  </c:pt>
                  <c:pt idx="1">
                    <c:v>MCM</c:v>
                  </c:pt>
                  <c:pt idx="2">
                    <c:v>Eto</c:v>
                  </c:pt>
                  <c:pt idx="3">
                    <c:v>L-165</c:v>
                  </c:pt>
                  <c:pt idx="4">
                    <c:v>Cont</c:v>
                  </c:pt>
                  <c:pt idx="5">
                    <c:v>MCM</c:v>
                  </c:pt>
                  <c:pt idx="6">
                    <c:v>Eto</c:v>
                  </c:pt>
                  <c:pt idx="7">
                    <c:v>L-165</c:v>
                  </c:pt>
                  <c:pt idx="8">
                    <c:v>Cont</c:v>
                  </c:pt>
                  <c:pt idx="9">
                    <c:v>MCM</c:v>
                  </c:pt>
                  <c:pt idx="10">
                    <c:v>Eto</c:v>
                  </c:pt>
                  <c:pt idx="11">
                    <c:v>L-165</c:v>
                  </c:pt>
                  <c:pt idx="12">
                    <c:v>Cont</c:v>
                  </c:pt>
                  <c:pt idx="13">
                    <c:v>MCM</c:v>
                  </c:pt>
                  <c:pt idx="14">
                    <c:v>Eto</c:v>
                  </c:pt>
                  <c:pt idx="15">
                    <c:v>L-165</c:v>
                  </c:pt>
                </c:lvl>
                <c:lvl>
                  <c:pt idx="0">
                    <c:v>NT</c:v>
                  </c:pt>
                  <c:pt idx="4">
                    <c:v>900</c:v>
                  </c:pt>
                  <c:pt idx="8">
                    <c:v>901</c:v>
                  </c:pt>
                  <c:pt idx="12">
                    <c:v>902</c:v>
                  </c:pt>
                </c:lvl>
              </c:multiLvlStrCache>
            </c:multiLvlStrRef>
          </c:cat>
          <c:val>
            <c:numRef>
              <c:f>'EMT 215'!$R$3:$R$18</c:f>
              <c:numCache>
                <c:formatCode>General</c:formatCode>
                <c:ptCount val="16"/>
                <c:pt idx="0">
                  <c:v>1.015816657224756</c:v>
                </c:pt>
                <c:pt idx="1">
                  <c:v>5.3965075494378656</c:v>
                </c:pt>
                <c:pt idx="2">
                  <c:v>5.0006806850483381</c:v>
                </c:pt>
                <c:pt idx="3">
                  <c:v>2.0232760499551712</c:v>
                </c:pt>
                <c:pt idx="4">
                  <c:v>1.080271353000126</c:v>
                </c:pt>
                <c:pt idx="5">
                  <c:v>3.1225825549912609</c:v>
                </c:pt>
                <c:pt idx="6">
                  <c:v>1.542331751298639</c:v>
                </c:pt>
                <c:pt idx="7">
                  <c:v>1.3688741966998821</c:v>
                </c:pt>
                <c:pt idx="8">
                  <c:v>1.035276903685926</c:v>
                </c:pt>
                <c:pt idx="9">
                  <c:v>2.616636745922865</c:v>
                </c:pt>
                <c:pt idx="10">
                  <c:v>1.6730148207475759</c:v>
                </c:pt>
                <c:pt idx="11">
                  <c:v>0.94077456533189496</c:v>
                </c:pt>
                <c:pt idx="12">
                  <c:v>1.022485324117973</c:v>
                </c:pt>
                <c:pt idx="13">
                  <c:v>2.7115889354338361</c:v>
                </c:pt>
                <c:pt idx="14">
                  <c:v>1.3868701268156951</c:v>
                </c:pt>
                <c:pt idx="15">
                  <c:v>1.4945154107660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B0F-0A4A-945E-B0F340D4C865}"/>
            </c:ext>
          </c:extLst>
        </c:ser>
        <c:ser>
          <c:idx val="5"/>
          <c:order val="4"/>
          <c:tx>
            <c:strRef>
              <c:f>'EMT 215'!$B$56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EMT 215'!$T$57:$T$72</c:f>
                <c:numCache>
                  <c:formatCode>General</c:formatCode>
                  <c:ptCount val="16"/>
                  <c:pt idx="0">
                    <c:v>0.15759533030306999</c:v>
                  </c:pt>
                  <c:pt idx="1">
                    <c:v>2.8858280353968522</c:v>
                  </c:pt>
                  <c:pt idx="2">
                    <c:v>1.543808604224445</c:v>
                  </c:pt>
                  <c:pt idx="3">
                    <c:v>2.705796543839261</c:v>
                  </c:pt>
                  <c:pt idx="4">
                    <c:v>0.23535536399683499</c:v>
                  </c:pt>
                  <c:pt idx="5">
                    <c:v>0.85577385826741903</c:v>
                  </c:pt>
                  <c:pt idx="6">
                    <c:v>0.24339470221890699</c:v>
                  </c:pt>
                  <c:pt idx="7">
                    <c:v>0.49605105608308198</c:v>
                  </c:pt>
                  <c:pt idx="8">
                    <c:v>5.8226550651988201E-2</c:v>
                  </c:pt>
                  <c:pt idx="9">
                    <c:v>1.0215788214340249</c:v>
                  </c:pt>
                  <c:pt idx="10">
                    <c:v>0.76301356290233102</c:v>
                  </c:pt>
                  <c:pt idx="11">
                    <c:v>0.51556334811261495</c:v>
                  </c:pt>
                  <c:pt idx="12">
                    <c:v>5.6588734762522699E-2</c:v>
                  </c:pt>
                  <c:pt idx="13">
                    <c:v>0.72556256453995105</c:v>
                  </c:pt>
                  <c:pt idx="14">
                    <c:v>0.51426808328877804</c:v>
                  </c:pt>
                  <c:pt idx="15">
                    <c:v>0.996714659329223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EMT 215'!$R$57:$R$72</c:f>
              <c:numCache>
                <c:formatCode>General</c:formatCode>
                <c:ptCount val="16"/>
                <c:pt idx="0">
                  <c:v>1.0456530327568301</c:v>
                </c:pt>
                <c:pt idx="1">
                  <c:v>10.87861398710692</c:v>
                </c:pt>
                <c:pt idx="2">
                  <c:v>3.5133544668817511</c:v>
                </c:pt>
                <c:pt idx="3">
                  <c:v>4.7117903378714017</c:v>
                </c:pt>
                <c:pt idx="4">
                  <c:v>1.087864366058003</c:v>
                </c:pt>
                <c:pt idx="5">
                  <c:v>3.3174448732200341</c:v>
                </c:pt>
                <c:pt idx="6">
                  <c:v>1.2483125040739429</c:v>
                </c:pt>
                <c:pt idx="7">
                  <c:v>1.7518405424386141</c:v>
                </c:pt>
                <c:pt idx="8">
                  <c:v>1.007705493381555</c:v>
                </c:pt>
                <c:pt idx="9">
                  <c:v>4.1267073255021849</c:v>
                </c:pt>
                <c:pt idx="10">
                  <c:v>2.054142095524607</c:v>
                </c:pt>
                <c:pt idx="11">
                  <c:v>1.281865088142506</c:v>
                </c:pt>
                <c:pt idx="12">
                  <c:v>1.007397139019689</c:v>
                </c:pt>
                <c:pt idx="13">
                  <c:v>3.9391215923333331</c:v>
                </c:pt>
                <c:pt idx="14">
                  <c:v>1.8506336536168799</c:v>
                </c:pt>
                <c:pt idx="15">
                  <c:v>3.8360807265802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B0F-0A4A-945E-B0F340D4C8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5612080"/>
        <c:axId val="285612640"/>
      </c:barChart>
      <c:catAx>
        <c:axId val="285612080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285612640"/>
        <c:crosses val="autoZero"/>
        <c:auto val="1"/>
        <c:lblAlgn val="ctr"/>
        <c:lblOffset val="100"/>
        <c:noMultiLvlLbl val="0"/>
      </c:catAx>
      <c:valAx>
        <c:axId val="285612640"/>
        <c:scaling>
          <c:orientation val="minMax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85612080"/>
        <c:crosses val="autoZero"/>
        <c:crossBetween val="between"/>
        <c:majorUnit val="4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4909</cdr:x>
      <cdr:y>0.55422</cdr:y>
    </cdr:from>
    <cdr:to>
      <cdr:x>0.39229</cdr:x>
      <cdr:y>0.63743</cdr:y>
    </cdr:to>
    <cdr:sp macro="" textlink="">
      <cdr:nvSpPr>
        <cdr:cNvPr id="2" name="TextBox 184"/>
        <cdr:cNvSpPr txBox="1"/>
      </cdr:nvSpPr>
      <cdr:spPr>
        <a:xfrm xmlns:a="http://schemas.openxmlformats.org/drawingml/2006/main">
          <a:off x="2295094" y="1332447"/>
          <a:ext cx="284052" cy="20005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700" b="1" dirty="0">
              <a:latin typeface="Arial" panose="020B0604020202020204" pitchFamily="34" charset="0"/>
              <a:cs typeface="Arial" panose="020B0604020202020204" pitchFamily="34" charset="0"/>
            </a:rPr>
            <a:t>##</a:t>
          </a:r>
          <a:endParaRPr lang="en-US" sz="7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802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0" name="Chart 319">
            <a:extLst>
              <a:ext uri="{FF2B5EF4-FFF2-40B4-BE49-F238E27FC236}">
                <a16:creationId xmlns:a16="http://schemas.microsoft.com/office/drawing/2014/main" id="{764A60B8-418A-E74A-835B-A8B4E5D6A7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972976"/>
              </p:ext>
            </p:extLst>
          </p:nvPr>
        </p:nvGraphicFramePr>
        <p:xfrm>
          <a:off x="183252" y="3422927"/>
          <a:ext cx="6730935" cy="25489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21" name="6 CuadroTexto">
            <a:extLst>
              <a:ext uri="{FF2B5EF4-FFF2-40B4-BE49-F238E27FC236}">
                <a16:creationId xmlns:a16="http://schemas.microsoft.com/office/drawing/2014/main" id="{3816D551-7245-C945-BBA7-74A11E5EEE60}"/>
              </a:ext>
            </a:extLst>
          </p:cNvPr>
          <p:cNvSpPr txBox="1"/>
          <p:nvPr/>
        </p:nvSpPr>
        <p:spPr>
          <a:xfrm>
            <a:off x="6000540" y="4001188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PDAC-253</a:t>
            </a:r>
          </a:p>
        </p:txBody>
      </p:sp>
      <p:sp>
        <p:nvSpPr>
          <p:cNvPr id="323" name="TextBox 53">
            <a:extLst>
              <a:ext uri="{FF2B5EF4-FFF2-40B4-BE49-F238E27FC236}">
                <a16:creationId xmlns:a16="http://schemas.microsoft.com/office/drawing/2014/main" id="{BFE30A48-509E-3444-9CD5-290DFD790F6E}"/>
              </a:ext>
            </a:extLst>
          </p:cNvPr>
          <p:cNvSpPr txBox="1"/>
          <p:nvPr/>
        </p:nvSpPr>
        <p:spPr>
          <a:xfrm rot="16200000">
            <a:off x="-984694" y="4750191"/>
            <a:ext cx="22573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Relative expression (fold change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4" name="Straight Connector 176">
            <a:extLst>
              <a:ext uri="{FF2B5EF4-FFF2-40B4-BE49-F238E27FC236}">
                <a16:creationId xmlns:a16="http://schemas.microsoft.com/office/drawing/2014/main" id="{2CEBE5CD-E1FC-8141-8FE3-55A2D03897AA}"/>
              </a:ext>
            </a:extLst>
          </p:cNvPr>
          <p:cNvCxnSpPr/>
          <p:nvPr/>
        </p:nvCxnSpPr>
        <p:spPr>
          <a:xfrm>
            <a:off x="940816" y="5191762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5" name="Straight Connector 176">
            <a:extLst>
              <a:ext uri="{FF2B5EF4-FFF2-40B4-BE49-F238E27FC236}">
                <a16:creationId xmlns:a16="http://schemas.microsoft.com/office/drawing/2014/main" id="{884AE068-8E61-3B4B-AEA2-B726E34818FD}"/>
              </a:ext>
            </a:extLst>
          </p:cNvPr>
          <p:cNvCxnSpPr/>
          <p:nvPr/>
        </p:nvCxnSpPr>
        <p:spPr>
          <a:xfrm>
            <a:off x="1357139" y="5552712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6" name="Straight Connector 176">
            <a:extLst>
              <a:ext uri="{FF2B5EF4-FFF2-40B4-BE49-F238E27FC236}">
                <a16:creationId xmlns:a16="http://schemas.microsoft.com/office/drawing/2014/main" id="{C260642B-9D8C-CA4B-87B2-9BE2AE137564}"/>
              </a:ext>
            </a:extLst>
          </p:cNvPr>
          <p:cNvCxnSpPr/>
          <p:nvPr/>
        </p:nvCxnSpPr>
        <p:spPr>
          <a:xfrm>
            <a:off x="1741048" y="421352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328" name="Chart 1">
            <a:extLst>
              <a:ext uri="{FF2B5EF4-FFF2-40B4-BE49-F238E27FC236}">
                <a16:creationId xmlns:a16="http://schemas.microsoft.com/office/drawing/2014/main" id="{2A4DE441-46F8-6F4F-AB1B-F7354C8C52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1830247"/>
              </p:ext>
            </p:extLst>
          </p:nvPr>
        </p:nvGraphicFramePr>
        <p:xfrm>
          <a:off x="261421" y="5681306"/>
          <a:ext cx="6574595" cy="24041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29" name="TextBox 138">
            <a:extLst>
              <a:ext uri="{FF2B5EF4-FFF2-40B4-BE49-F238E27FC236}">
                <a16:creationId xmlns:a16="http://schemas.microsoft.com/office/drawing/2014/main" id="{48B7A37B-C0F7-4A47-A721-6D6CA8D27CE5}"/>
              </a:ext>
            </a:extLst>
          </p:cNvPr>
          <p:cNvSpPr txBox="1"/>
          <p:nvPr/>
        </p:nvSpPr>
        <p:spPr>
          <a:xfrm>
            <a:off x="882059" y="8002679"/>
            <a:ext cx="455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139">
            <a:extLst>
              <a:ext uri="{FF2B5EF4-FFF2-40B4-BE49-F238E27FC236}">
                <a16:creationId xmlns:a16="http://schemas.microsoft.com/office/drawing/2014/main" id="{F948D97E-F5DF-9146-9E71-4F7EBCA03B47}"/>
              </a:ext>
            </a:extLst>
          </p:cNvPr>
          <p:cNvSpPr txBox="1"/>
          <p:nvPr/>
        </p:nvSpPr>
        <p:spPr>
          <a:xfrm>
            <a:off x="1322120" y="8002679"/>
            <a:ext cx="361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t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TextBox 139">
            <a:extLst>
              <a:ext uri="{FF2B5EF4-FFF2-40B4-BE49-F238E27FC236}">
                <a16:creationId xmlns:a16="http://schemas.microsoft.com/office/drawing/2014/main" id="{7692A75A-C213-2A47-B21C-E3B3DC0C4F2A}"/>
              </a:ext>
            </a:extLst>
          </p:cNvPr>
          <p:cNvSpPr txBox="1"/>
          <p:nvPr/>
        </p:nvSpPr>
        <p:spPr>
          <a:xfrm>
            <a:off x="1631977" y="800267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L-16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138">
            <a:extLst>
              <a:ext uri="{FF2B5EF4-FFF2-40B4-BE49-F238E27FC236}">
                <a16:creationId xmlns:a16="http://schemas.microsoft.com/office/drawing/2014/main" id="{0FABAB33-A40E-C146-9C3E-013429EFAAA1}"/>
              </a:ext>
            </a:extLst>
          </p:cNvPr>
          <p:cNvSpPr txBox="1"/>
          <p:nvPr/>
        </p:nvSpPr>
        <p:spPr>
          <a:xfrm>
            <a:off x="520636" y="80026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138">
            <a:extLst>
              <a:ext uri="{FF2B5EF4-FFF2-40B4-BE49-F238E27FC236}">
                <a16:creationId xmlns:a16="http://schemas.microsoft.com/office/drawing/2014/main" id="{8FEB8D0E-314E-E940-B2F1-85C7C602102D}"/>
              </a:ext>
            </a:extLst>
          </p:cNvPr>
          <p:cNvSpPr txBox="1"/>
          <p:nvPr/>
        </p:nvSpPr>
        <p:spPr>
          <a:xfrm>
            <a:off x="2452132" y="8002679"/>
            <a:ext cx="455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139">
            <a:extLst>
              <a:ext uri="{FF2B5EF4-FFF2-40B4-BE49-F238E27FC236}">
                <a16:creationId xmlns:a16="http://schemas.microsoft.com/office/drawing/2014/main" id="{AECAA068-C0AB-194A-A684-9D089AB9240C}"/>
              </a:ext>
            </a:extLst>
          </p:cNvPr>
          <p:cNvSpPr txBox="1"/>
          <p:nvPr/>
        </p:nvSpPr>
        <p:spPr>
          <a:xfrm>
            <a:off x="2870421" y="8002679"/>
            <a:ext cx="361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t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139">
            <a:extLst>
              <a:ext uri="{FF2B5EF4-FFF2-40B4-BE49-F238E27FC236}">
                <a16:creationId xmlns:a16="http://schemas.microsoft.com/office/drawing/2014/main" id="{E2361331-1FB1-A549-8E85-A4552D33974F}"/>
              </a:ext>
            </a:extLst>
          </p:cNvPr>
          <p:cNvSpPr txBox="1"/>
          <p:nvPr/>
        </p:nvSpPr>
        <p:spPr>
          <a:xfrm>
            <a:off x="3202050" y="800267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L-16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138">
            <a:extLst>
              <a:ext uri="{FF2B5EF4-FFF2-40B4-BE49-F238E27FC236}">
                <a16:creationId xmlns:a16="http://schemas.microsoft.com/office/drawing/2014/main" id="{942818B8-B528-EC4A-A58F-4C9F60631298}"/>
              </a:ext>
            </a:extLst>
          </p:cNvPr>
          <p:cNvSpPr txBox="1"/>
          <p:nvPr/>
        </p:nvSpPr>
        <p:spPr>
          <a:xfrm>
            <a:off x="2090709" y="80026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138">
            <a:extLst>
              <a:ext uri="{FF2B5EF4-FFF2-40B4-BE49-F238E27FC236}">
                <a16:creationId xmlns:a16="http://schemas.microsoft.com/office/drawing/2014/main" id="{1BFBAC01-3C92-914F-A9D7-DF8838124686}"/>
              </a:ext>
            </a:extLst>
          </p:cNvPr>
          <p:cNvSpPr txBox="1"/>
          <p:nvPr/>
        </p:nvSpPr>
        <p:spPr>
          <a:xfrm>
            <a:off x="3993022" y="8002679"/>
            <a:ext cx="455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139">
            <a:extLst>
              <a:ext uri="{FF2B5EF4-FFF2-40B4-BE49-F238E27FC236}">
                <a16:creationId xmlns:a16="http://schemas.microsoft.com/office/drawing/2014/main" id="{F5515ACC-FFB9-CA4D-AA09-01DBF31D0772}"/>
              </a:ext>
            </a:extLst>
          </p:cNvPr>
          <p:cNvSpPr txBox="1"/>
          <p:nvPr/>
        </p:nvSpPr>
        <p:spPr>
          <a:xfrm>
            <a:off x="4443969" y="8002679"/>
            <a:ext cx="361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t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139">
            <a:extLst>
              <a:ext uri="{FF2B5EF4-FFF2-40B4-BE49-F238E27FC236}">
                <a16:creationId xmlns:a16="http://schemas.microsoft.com/office/drawing/2014/main" id="{09C82E08-6BF0-9349-9D24-DC61851F2AE0}"/>
              </a:ext>
            </a:extLst>
          </p:cNvPr>
          <p:cNvSpPr txBox="1"/>
          <p:nvPr/>
        </p:nvSpPr>
        <p:spPr>
          <a:xfrm>
            <a:off x="4742940" y="800267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L-16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138">
            <a:extLst>
              <a:ext uri="{FF2B5EF4-FFF2-40B4-BE49-F238E27FC236}">
                <a16:creationId xmlns:a16="http://schemas.microsoft.com/office/drawing/2014/main" id="{67FDEC44-A2B9-1B48-A172-641EF11E3F1E}"/>
              </a:ext>
            </a:extLst>
          </p:cNvPr>
          <p:cNvSpPr txBox="1"/>
          <p:nvPr/>
        </p:nvSpPr>
        <p:spPr>
          <a:xfrm>
            <a:off x="3629125" y="80026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138">
            <a:extLst>
              <a:ext uri="{FF2B5EF4-FFF2-40B4-BE49-F238E27FC236}">
                <a16:creationId xmlns:a16="http://schemas.microsoft.com/office/drawing/2014/main" id="{F8213214-131F-2F4F-B3E7-403C91BF1016}"/>
              </a:ext>
            </a:extLst>
          </p:cNvPr>
          <p:cNvSpPr txBox="1"/>
          <p:nvPr/>
        </p:nvSpPr>
        <p:spPr>
          <a:xfrm>
            <a:off x="5561812" y="8002679"/>
            <a:ext cx="455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CM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139">
            <a:extLst>
              <a:ext uri="{FF2B5EF4-FFF2-40B4-BE49-F238E27FC236}">
                <a16:creationId xmlns:a16="http://schemas.microsoft.com/office/drawing/2014/main" id="{9B0EAAD8-F44D-2A43-BD97-706C39A40122}"/>
              </a:ext>
            </a:extLst>
          </p:cNvPr>
          <p:cNvSpPr txBox="1"/>
          <p:nvPr/>
        </p:nvSpPr>
        <p:spPr>
          <a:xfrm>
            <a:off x="6012759" y="8002679"/>
            <a:ext cx="361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t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139">
            <a:extLst>
              <a:ext uri="{FF2B5EF4-FFF2-40B4-BE49-F238E27FC236}">
                <a16:creationId xmlns:a16="http://schemas.microsoft.com/office/drawing/2014/main" id="{B7B56F4E-895C-144E-A087-36CD00592F08}"/>
              </a:ext>
            </a:extLst>
          </p:cNvPr>
          <p:cNvSpPr txBox="1"/>
          <p:nvPr/>
        </p:nvSpPr>
        <p:spPr>
          <a:xfrm>
            <a:off x="6322616" y="8002679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L-16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TextBox 138">
            <a:extLst>
              <a:ext uri="{FF2B5EF4-FFF2-40B4-BE49-F238E27FC236}">
                <a16:creationId xmlns:a16="http://schemas.microsoft.com/office/drawing/2014/main" id="{A2C19448-5466-6949-B544-178F4702E081}"/>
              </a:ext>
            </a:extLst>
          </p:cNvPr>
          <p:cNvSpPr txBox="1"/>
          <p:nvPr/>
        </p:nvSpPr>
        <p:spPr>
          <a:xfrm>
            <a:off x="5197915" y="800267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5" name="121 Conector recto">
            <a:extLst>
              <a:ext uri="{FF2B5EF4-FFF2-40B4-BE49-F238E27FC236}">
                <a16:creationId xmlns:a16="http://schemas.microsoft.com/office/drawing/2014/main" id="{BD49B352-EB08-8448-A73A-50A0B0D8EA1D}"/>
              </a:ext>
            </a:extLst>
          </p:cNvPr>
          <p:cNvCxnSpPr/>
          <p:nvPr/>
        </p:nvCxnSpPr>
        <p:spPr>
          <a:xfrm>
            <a:off x="549328" y="8248900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122 Conector recto">
            <a:extLst>
              <a:ext uri="{FF2B5EF4-FFF2-40B4-BE49-F238E27FC236}">
                <a16:creationId xmlns:a16="http://schemas.microsoft.com/office/drawing/2014/main" id="{DEC4448C-E7E6-314E-9AA2-AB7EEACE5A3A}"/>
              </a:ext>
            </a:extLst>
          </p:cNvPr>
          <p:cNvCxnSpPr/>
          <p:nvPr/>
        </p:nvCxnSpPr>
        <p:spPr>
          <a:xfrm>
            <a:off x="2131285" y="8248900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7" name="123 Conector recto">
            <a:extLst>
              <a:ext uri="{FF2B5EF4-FFF2-40B4-BE49-F238E27FC236}">
                <a16:creationId xmlns:a16="http://schemas.microsoft.com/office/drawing/2014/main" id="{4493ACA4-DD81-2946-A864-5544662E8D28}"/>
              </a:ext>
            </a:extLst>
          </p:cNvPr>
          <p:cNvCxnSpPr/>
          <p:nvPr/>
        </p:nvCxnSpPr>
        <p:spPr>
          <a:xfrm>
            <a:off x="3668817" y="8248900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124 Conector recto">
            <a:extLst>
              <a:ext uri="{FF2B5EF4-FFF2-40B4-BE49-F238E27FC236}">
                <a16:creationId xmlns:a16="http://schemas.microsoft.com/office/drawing/2014/main" id="{C54F00BF-B68D-5B4C-B147-CE77AEC12E98}"/>
              </a:ext>
            </a:extLst>
          </p:cNvPr>
          <p:cNvCxnSpPr/>
          <p:nvPr/>
        </p:nvCxnSpPr>
        <p:spPr>
          <a:xfrm>
            <a:off x="5265061" y="8248900"/>
            <a:ext cx="144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9" name="125 CuadroTexto">
            <a:extLst>
              <a:ext uri="{FF2B5EF4-FFF2-40B4-BE49-F238E27FC236}">
                <a16:creationId xmlns:a16="http://schemas.microsoft.com/office/drawing/2014/main" id="{9DA70F85-5F2D-074A-BA94-CEDF83D155A6}"/>
              </a:ext>
            </a:extLst>
          </p:cNvPr>
          <p:cNvSpPr txBox="1"/>
          <p:nvPr/>
        </p:nvSpPr>
        <p:spPr>
          <a:xfrm>
            <a:off x="1098987" y="8252371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50" b="1" dirty="0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424A9715-8736-C640-92E3-5786847EBCD2}"/>
              </a:ext>
            </a:extLst>
          </p:cNvPr>
          <p:cNvSpPr txBox="1"/>
          <p:nvPr/>
        </p:nvSpPr>
        <p:spPr>
          <a:xfrm>
            <a:off x="2371827" y="825336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PARD sh#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3C2CBDE2-BF4D-904A-A9DD-169C9E719EA5}"/>
              </a:ext>
            </a:extLst>
          </p:cNvPr>
          <p:cNvSpPr txBox="1"/>
          <p:nvPr/>
        </p:nvSpPr>
        <p:spPr>
          <a:xfrm>
            <a:off x="3909359" y="825336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PARD sh#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TextBox 137">
            <a:extLst>
              <a:ext uri="{FF2B5EF4-FFF2-40B4-BE49-F238E27FC236}">
                <a16:creationId xmlns:a16="http://schemas.microsoft.com/office/drawing/2014/main" id="{2B80F905-7AE6-A743-8D5B-E0461C8BDCC5}"/>
              </a:ext>
            </a:extLst>
          </p:cNvPr>
          <p:cNvSpPr txBox="1"/>
          <p:nvPr/>
        </p:nvSpPr>
        <p:spPr>
          <a:xfrm>
            <a:off x="5505603" y="8253369"/>
            <a:ext cx="9589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PARD sh#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5" name="TextBox 184">
            <a:extLst>
              <a:ext uri="{FF2B5EF4-FFF2-40B4-BE49-F238E27FC236}">
                <a16:creationId xmlns:a16="http://schemas.microsoft.com/office/drawing/2014/main" id="{1F11E75D-34F3-564C-AACF-022E180967B3}"/>
              </a:ext>
            </a:extLst>
          </p:cNvPr>
          <p:cNvSpPr txBox="1"/>
          <p:nvPr/>
        </p:nvSpPr>
        <p:spPr>
          <a:xfrm>
            <a:off x="1386715" y="5369043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26" name="TextBox 184">
            <a:extLst>
              <a:ext uri="{FF2B5EF4-FFF2-40B4-BE49-F238E27FC236}">
                <a16:creationId xmlns:a16="http://schemas.microsoft.com/office/drawing/2014/main" id="{764C5177-1CB7-1044-BACF-A0FD630014DB}"/>
              </a:ext>
            </a:extLst>
          </p:cNvPr>
          <p:cNvSpPr txBox="1"/>
          <p:nvPr/>
        </p:nvSpPr>
        <p:spPr>
          <a:xfrm>
            <a:off x="984310" y="499183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7" name="TextBox 184">
            <a:extLst>
              <a:ext uri="{FF2B5EF4-FFF2-40B4-BE49-F238E27FC236}">
                <a16:creationId xmlns:a16="http://schemas.microsoft.com/office/drawing/2014/main" id="{15C84E82-770E-B848-9CF2-04B8D169CBE0}"/>
              </a:ext>
            </a:extLst>
          </p:cNvPr>
          <p:cNvSpPr txBox="1"/>
          <p:nvPr/>
        </p:nvSpPr>
        <p:spPr>
          <a:xfrm>
            <a:off x="1783784" y="403953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8" name="TextBox 184">
            <a:extLst>
              <a:ext uri="{FF2B5EF4-FFF2-40B4-BE49-F238E27FC236}">
                <a16:creationId xmlns:a16="http://schemas.microsoft.com/office/drawing/2014/main" id="{FD928DF7-630B-0F4F-AB3B-EF82E64FD508}"/>
              </a:ext>
            </a:extLst>
          </p:cNvPr>
          <p:cNvSpPr txBox="1"/>
          <p:nvPr/>
        </p:nvSpPr>
        <p:spPr>
          <a:xfrm>
            <a:off x="1417941" y="641560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9" name="Straight Connector 176">
            <a:extLst>
              <a:ext uri="{FF2B5EF4-FFF2-40B4-BE49-F238E27FC236}">
                <a16:creationId xmlns:a16="http://schemas.microsoft.com/office/drawing/2014/main" id="{B5081E95-EBAC-EC48-965F-1A0203F90587}"/>
              </a:ext>
            </a:extLst>
          </p:cNvPr>
          <p:cNvCxnSpPr/>
          <p:nvPr/>
        </p:nvCxnSpPr>
        <p:spPr>
          <a:xfrm>
            <a:off x="2489917" y="5686513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0" name="Straight Connector 176">
            <a:extLst>
              <a:ext uri="{FF2B5EF4-FFF2-40B4-BE49-F238E27FC236}">
                <a16:creationId xmlns:a16="http://schemas.microsoft.com/office/drawing/2014/main" id="{5F26E3BA-586A-A442-81FF-F4A283EC4EA8}"/>
              </a:ext>
            </a:extLst>
          </p:cNvPr>
          <p:cNvCxnSpPr/>
          <p:nvPr/>
        </p:nvCxnSpPr>
        <p:spPr>
          <a:xfrm>
            <a:off x="2869628" y="5669332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1" name="Straight Connector 176">
            <a:extLst>
              <a:ext uri="{FF2B5EF4-FFF2-40B4-BE49-F238E27FC236}">
                <a16:creationId xmlns:a16="http://schemas.microsoft.com/office/drawing/2014/main" id="{5B5D163A-32DC-964E-B1B6-C96839D9E93D}"/>
              </a:ext>
            </a:extLst>
          </p:cNvPr>
          <p:cNvCxnSpPr/>
          <p:nvPr/>
        </p:nvCxnSpPr>
        <p:spPr>
          <a:xfrm>
            <a:off x="3281088" y="5569870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2" name="Straight Connector 176">
            <a:extLst>
              <a:ext uri="{FF2B5EF4-FFF2-40B4-BE49-F238E27FC236}">
                <a16:creationId xmlns:a16="http://schemas.microsoft.com/office/drawing/2014/main" id="{31132A9D-AC75-FD44-ABCD-0FEA9D0046CD}"/>
              </a:ext>
            </a:extLst>
          </p:cNvPr>
          <p:cNvCxnSpPr/>
          <p:nvPr/>
        </p:nvCxnSpPr>
        <p:spPr>
          <a:xfrm>
            <a:off x="4045534" y="5628974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3" name="TextBox 184">
            <a:extLst>
              <a:ext uri="{FF2B5EF4-FFF2-40B4-BE49-F238E27FC236}">
                <a16:creationId xmlns:a16="http://schemas.microsoft.com/office/drawing/2014/main" id="{B0E51D7D-13DE-5444-97FA-701AABDFD6CD}"/>
              </a:ext>
            </a:extLst>
          </p:cNvPr>
          <p:cNvSpPr txBox="1"/>
          <p:nvPr/>
        </p:nvSpPr>
        <p:spPr>
          <a:xfrm>
            <a:off x="2504924" y="552735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4" name="Straight Connector 176">
            <a:extLst>
              <a:ext uri="{FF2B5EF4-FFF2-40B4-BE49-F238E27FC236}">
                <a16:creationId xmlns:a16="http://schemas.microsoft.com/office/drawing/2014/main" id="{2B3A77D1-B3EC-D641-BB0A-72F4C7D8AB35}"/>
              </a:ext>
            </a:extLst>
          </p:cNvPr>
          <p:cNvCxnSpPr/>
          <p:nvPr/>
        </p:nvCxnSpPr>
        <p:spPr>
          <a:xfrm>
            <a:off x="4442001" y="5714341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5" name="Straight Connector 176">
            <a:extLst>
              <a:ext uri="{FF2B5EF4-FFF2-40B4-BE49-F238E27FC236}">
                <a16:creationId xmlns:a16="http://schemas.microsoft.com/office/drawing/2014/main" id="{36BEBDD2-AB83-4340-B652-3B1A7296C211}"/>
              </a:ext>
            </a:extLst>
          </p:cNvPr>
          <p:cNvCxnSpPr/>
          <p:nvPr/>
        </p:nvCxnSpPr>
        <p:spPr>
          <a:xfrm>
            <a:off x="4843836" y="5591263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6" name="Straight Connector 176">
            <a:extLst>
              <a:ext uri="{FF2B5EF4-FFF2-40B4-BE49-F238E27FC236}">
                <a16:creationId xmlns:a16="http://schemas.microsoft.com/office/drawing/2014/main" id="{560B08C5-73C1-2742-A236-776B1C5ED799}"/>
              </a:ext>
            </a:extLst>
          </p:cNvPr>
          <p:cNvCxnSpPr/>
          <p:nvPr/>
        </p:nvCxnSpPr>
        <p:spPr>
          <a:xfrm>
            <a:off x="6397924" y="541694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7" name="Straight Connector 176">
            <a:extLst>
              <a:ext uri="{FF2B5EF4-FFF2-40B4-BE49-F238E27FC236}">
                <a16:creationId xmlns:a16="http://schemas.microsoft.com/office/drawing/2014/main" id="{B9DF6390-18CC-634A-9B51-74B9453FCE80}"/>
              </a:ext>
            </a:extLst>
          </p:cNvPr>
          <p:cNvCxnSpPr/>
          <p:nvPr/>
        </p:nvCxnSpPr>
        <p:spPr>
          <a:xfrm>
            <a:off x="6016606" y="5674645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8" name="Straight Connector 176">
            <a:extLst>
              <a:ext uri="{FF2B5EF4-FFF2-40B4-BE49-F238E27FC236}">
                <a16:creationId xmlns:a16="http://schemas.microsoft.com/office/drawing/2014/main" id="{FC48D0F9-954C-DC45-A514-8D3A675C8AAB}"/>
              </a:ext>
            </a:extLst>
          </p:cNvPr>
          <p:cNvCxnSpPr/>
          <p:nvPr/>
        </p:nvCxnSpPr>
        <p:spPr>
          <a:xfrm>
            <a:off x="5639868" y="5665310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9" name="TextBox 184">
            <a:extLst>
              <a:ext uri="{FF2B5EF4-FFF2-40B4-BE49-F238E27FC236}">
                <a16:creationId xmlns:a16="http://schemas.microsoft.com/office/drawing/2014/main" id="{FF03A90F-9086-5545-A423-673F76EB2E18}"/>
              </a:ext>
            </a:extLst>
          </p:cNvPr>
          <p:cNvSpPr txBox="1"/>
          <p:nvPr/>
        </p:nvSpPr>
        <p:spPr>
          <a:xfrm>
            <a:off x="2886921" y="5495743"/>
            <a:ext cx="2840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0" name="TextBox 184">
            <a:extLst>
              <a:ext uri="{FF2B5EF4-FFF2-40B4-BE49-F238E27FC236}">
                <a16:creationId xmlns:a16="http://schemas.microsoft.com/office/drawing/2014/main" id="{CF39B583-5BD5-EC4B-9877-499ECEFBD37E}"/>
              </a:ext>
            </a:extLst>
          </p:cNvPr>
          <p:cNvSpPr txBox="1"/>
          <p:nvPr/>
        </p:nvSpPr>
        <p:spPr>
          <a:xfrm>
            <a:off x="3311348" y="537905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TextBox 184">
            <a:extLst>
              <a:ext uri="{FF2B5EF4-FFF2-40B4-BE49-F238E27FC236}">
                <a16:creationId xmlns:a16="http://schemas.microsoft.com/office/drawing/2014/main" id="{E51AB851-72E4-2F43-8AB9-83CBCBC37F1F}"/>
              </a:ext>
            </a:extLst>
          </p:cNvPr>
          <p:cNvSpPr txBox="1"/>
          <p:nvPr/>
        </p:nvSpPr>
        <p:spPr>
          <a:xfrm>
            <a:off x="4092525" y="545499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2" name="TextBox 184">
            <a:extLst>
              <a:ext uri="{FF2B5EF4-FFF2-40B4-BE49-F238E27FC236}">
                <a16:creationId xmlns:a16="http://schemas.microsoft.com/office/drawing/2014/main" id="{5E9BE53E-7E48-F64D-8A26-56F983A8F142}"/>
              </a:ext>
            </a:extLst>
          </p:cNvPr>
          <p:cNvSpPr txBox="1"/>
          <p:nvPr/>
        </p:nvSpPr>
        <p:spPr>
          <a:xfrm>
            <a:off x="4490640" y="553859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TextBox 184">
            <a:extLst>
              <a:ext uri="{FF2B5EF4-FFF2-40B4-BE49-F238E27FC236}">
                <a16:creationId xmlns:a16="http://schemas.microsoft.com/office/drawing/2014/main" id="{4200FBFC-97E4-114D-93E5-663232EA0CD3}"/>
              </a:ext>
            </a:extLst>
          </p:cNvPr>
          <p:cNvSpPr txBox="1"/>
          <p:nvPr/>
        </p:nvSpPr>
        <p:spPr>
          <a:xfrm>
            <a:off x="4903826" y="542380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TextBox 184">
            <a:extLst>
              <a:ext uri="{FF2B5EF4-FFF2-40B4-BE49-F238E27FC236}">
                <a16:creationId xmlns:a16="http://schemas.microsoft.com/office/drawing/2014/main" id="{A9A3EE31-27F8-E142-8773-A118F9B3AD16}"/>
              </a:ext>
            </a:extLst>
          </p:cNvPr>
          <p:cNvSpPr txBox="1"/>
          <p:nvPr/>
        </p:nvSpPr>
        <p:spPr>
          <a:xfrm>
            <a:off x="5691652" y="549574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5" name="TextBox 184">
            <a:extLst>
              <a:ext uri="{FF2B5EF4-FFF2-40B4-BE49-F238E27FC236}">
                <a16:creationId xmlns:a16="http://schemas.microsoft.com/office/drawing/2014/main" id="{EDE19A00-7FAC-D545-AE6F-E87BB88DD61C}"/>
              </a:ext>
            </a:extLst>
          </p:cNvPr>
          <p:cNvSpPr txBox="1"/>
          <p:nvPr/>
        </p:nvSpPr>
        <p:spPr>
          <a:xfrm>
            <a:off x="6054574" y="5495743"/>
            <a:ext cx="23979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TextBox 184">
            <a:extLst>
              <a:ext uri="{FF2B5EF4-FFF2-40B4-BE49-F238E27FC236}">
                <a16:creationId xmlns:a16="http://schemas.microsoft.com/office/drawing/2014/main" id="{BECDC407-DB08-FD44-AC35-C8D2F948D542}"/>
              </a:ext>
            </a:extLst>
          </p:cNvPr>
          <p:cNvSpPr txBox="1"/>
          <p:nvPr/>
        </p:nvSpPr>
        <p:spPr>
          <a:xfrm>
            <a:off x="6448516" y="521942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7" name="Straight Connector 176">
            <a:extLst>
              <a:ext uri="{FF2B5EF4-FFF2-40B4-BE49-F238E27FC236}">
                <a16:creationId xmlns:a16="http://schemas.microsoft.com/office/drawing/2014/main" id="{7478C24E-25CC-224A-BA1F-E6E10C260031}"/>
              </a:ext>
            </a:extLst>
          </p:cNvPr>
          <p:cNvCxnSpPr/>
          <p:nvPr/>
        </p:nvCxnSpPr>
        <p:spPr>
          <a:xfrm>
            <a:off x="2551790" y="7199763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8" name="Straight Connector 176">
            <a:extLst>
              <a:ext uri="{FF2B5EF4-FFF2-40B4-BE49-F238E27FC236}">
                <a16:creationId xmlns:a16="http://schemas.microsoft.com/office/drawing/2014/main" id="{21731DC9-1D04-2D42-9F96-3E1A804EF510}"/>
              </a:ext>
            </a:extLst>
          </p:cNvPr>
          <p:cNvCxnSpPr/>
          <p:nvPr/>
        </p:nvCxnSpPr>
        <p:spPr>
          <a:xfrm>
            <a:off x="2944503" y="7182582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9" name="Straight Connector 176">
            <a:extLst>
              <a:ext uri="{FF2B5EF4-FFF2-40B4-BE49-F238E27FC236}">
                <a16:creationId xmlns:a16="http://schemas.microsoft.com/office/drawing/2014/main" id="{EB01C767-C9C3-BC47-B2D2-D40176D86AF2}"/>
              </a:ext>
            </a:extLst>
          </p:cNvPr>
          <p:cNvCxnSpPr/>
          <p:nvPr/>
        </p:nvCxnSpPr>
        <p:spPr>
          <a:xfrm>
            <a:off x="3342961" y="7159320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0" name="Straight Connector 176">
            <a:extLst>
              <a:ext uri="{FF2B5EF4-FFF2-40B4-BE49-F238E27FC236}">
                <a16:creationId xmlns:a16="http://schemas.microsoft.com/office/drawing/2014/main" id="{F4A01F8E-7AE6-D74A-9451-294FEBF26807}"/>
              </a:ext>
            </a:extLst>
          </p:cNvPr>
          <p:cNvCxnSpPr/>
          <p:nvPr/>
        </p:nvCxnSpPr>
        <p:spPr>
          <a:xfrm>
            <a:off x="4116075" y="6970774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1" name="Straight Connector 176">
            <a:extLst>
              <a:ext uri="{FF2B5EF4-FFF2-40B4-BE49-F238E27FC236}">
                <a16:creationId xmlns:a16="http://schemas.microsoft.com/office/drawing/2014/main" id="{E097F2E2-1D9D-FE42-892E-6B610B59DE09}"/>
              </a:ext>
            </a:extLst>
          </p:cNvPr>
          <p:cNvCxnSpPr/>
          <p:nvPr/>
        </p:nvCxnSpPr>
        <p:spPr>
          <a:xfrm>
            <a:off x="4512542" y="708471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2" name="Straight Connector 176">
            <a:extLst>
              <a:ext uri="{FF2B5EF4-FFF2-40B4-BE49-F238E27FC236}">
                <a16:creationId xmlns:a16="http://schemas.microsoft.com/office/drawing/2014/main" id="{DDC047E0-B41B-8E48-8290-CF5F10E586C1}"/>
              </a:ext>
            </a:extLst>
          </p:cNvPr>
          <p:cNvCxnSpPr/>
          <p:nvPr/>
        </p:nvCxnSpPr>
        <p:spPr>
          <a:xfrm>
            <a:off x="4914377" y="7199763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3" name="Straight Connector 176">
            <a:extLst>
              <a:ext uri="{FF2B5EF4-FFF2-40B4-BE49-F238E27FC236}">
                <a16:creationId xmlns:a16="http://schemas.microsoft.com/office/drawing/2014/main" id="{C90D15B7-0B9B-0341-AE57-E27265EF2DC8}"/>
              </a:ext>
            </a:extLst>
          </p:cNvPr>
          <p:cNvCxnSpPr/>
          <p:nvPr/>
        </p:nvCxnSpPr>
        <p:spPr>
          <a:xfrm>
            <a:off x="6442461" y="7149271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4" name="Straight Connector 176">
            <a:extLst>
              <a:ext uri="{FF2B5EF4-FFF2-40B4-BE49-F238E27FC236}">
                <a16:creationId xmlns:a16="http://schemas.microsoft.com/office/drawing/2014/main" id="{AFECD089-0ADC-DB48-81DB-A6E69679D1D3}"/>
              </a:ext>
            </a:extLst>
          </p:cNvPr>
          <p:cNvCxnSpPr/>
          <p:nvPr/>
        </p:nvCxnSpPr>
        <p:spPr>
          <a:xfrm>
            <a:off x="6061143" y="7130745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5" name="Straight Connector 176">
            <a:extLst>
              <a:ext uri="{FF2B5EF4-FFF2-40B4-BE49-F238E27FC236}">
                <a16:creationId xmlns:a16="http://schemas.microsoft.com/office/drawing/2014/main" id="{B27BF2D5-8672-FE48-88C1-ADD0A5274183}"/>
              </a:ext>
            </a:extLst>
          </p:cNvPr>
          <p:cNvCxnSpPr/>
          <p:nvPr/>
        </p:nvCxnSpPr>
        <p:spPr>
          <a:xfrm>
            <a:off x="5684405" y="6826135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6" name="TextBox 184">
            <a:extLst>
              <a:ext uri="{FF2B5EF4-FFF2-40B4-BE49-F238E27FC236}">
                <a16:creationId xmlns:a16="http://schemas.microsoft.com/office/drawing/2014/main" id="{C789DCF2-87F1-6D48-A0A4-5DDC0107F6A8}"/>
              </a:ext>
            </a:extLst>
          </p:cNvPr>
          <p:cNvSpPr txBox="1"/>
          <p:nvPr/>
        </p:nvSpPr>
        <p:spPr>
          <a:xfrm>
            <a:off x="2967005" y="700748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TextBox 184">
            <a:extLst>
              <a:ext uri="{FF2B5EF4-FFF2-40B4-BE49-F238E27FC236}">
                <a16:creationId xmlns:a16="http://schemas.microsoft.com/office/drawing/2014/main" id="{99C8B6FD-0EBF-FB4A-B130-04F11522B73B}"/>
              </a:ext>
            </a:extLst>
          </p:cNvPr>
          <p:cNvSpPr txBox="1"/>
          <p:nvPr/>
        </p:nvSpPr>
        <p:spPr>
          <a:xfrm>
            <a:off x="3377386" y="697644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TextBox 184">
            <a:extLst>
              <a:ext uri="{FF2B5EF4-FFF2-40B4-BE49-F238E27FC236}">
                <a16:creationId xmlns:a16="http://schemas.microsoft.com/office/drawing/2014/main" id="{ADA81CD7-943B-A94E-B495-962CA14F7D75}"/>
              </a:ext>
            </a:extLst>
          </p:cNvPr>
          <p:cNvSpPr txBox="1"/>
          <p:nvPr/>
        </p:nvSpPr>
        <p:spPr>
          <a:xfrm>
            <a:off x="4120473" y="680742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TextBox 184">
            <a:extLst>
              <a:ext uri="{FF2B5EF4-FFF2-40B4-BE49-F238E27FC236}">
                <a16:creationId xmlns:a16="http://schemas.microsoft.com/office/drawing/2014/main" id="{C91BEC74-CE65-4649-AE17-ABFBB723B2FA}"/>
              </a:ext>
            </a:extLst>
          </p:cNvPr>
          <p:cNvSpPr txBox="1"/>
          <p:nvPr/>
        </p:nvSpPr>
        <p:spPr>
          <a:xfrm>
            <a:off x="4542738" y="691018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TextBox 184">
            <a:extLst>
              <a:ext uri="{FF2B5EF4-FFF2-40B4-BE49-F238E27FC236}">
                <a16:creationId xmlns:a16="http://schemas.microsoft.com/office/drawing/2014/main" id="{F8D3BCDB-EE78-0F45-9816-93B7208A020B}"/>
              </a:ext>
            </a:extLst>
          </p:cNvPr>
          <p:cNvSpPr txBox="1"/>
          <p:nvPr/>
        </p:nvSpPr>
        <p:spPr>
          <a:xfrm>
            <a:off x="4945515" y="7037448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TextBox 184">
            <a:extLst>
              <a:ext uri="{FF2B5EF4-FFF2-40B4-BE49-F238E27FC236}">
                <a16:creationId xmlns:a16="http://schemas.microsoft.com/office/drawing/2014/main" id="{F7A14695-7147-D04C-BA0D-15AD5F94AA2A}"/>
              </a:ext>
            </a:extLst>
          </p:cNvPr>
          <p:cNvSpPr txBox="1"/>
          <p:nvPr/>
        </p:nvSpPr>
        <p:spPr>
          <a:xfrm>
            <a:off x="5732268" y="664476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TextBox 184">
            <a:extLst>
              <a:ext uri="{FF2B5EF4-FFF2-40B4-BE49-F238E27FC236}">
                <a16:creationId xmlns:a16="http://schemas.microsoft.com/office/drawing/2014/main" id="{A8E79EF6-E369-ED49-9F9F-60C387E11C53}"/>
              </a:ext>
            </a:extLst>
          </p:cNvPr>
          <p:cNvSpPr txBox="1"/>
          <p:nvPr/>
        </p:nvSpPr>
        <p:spPr>
          <a:xfrm>
            <a:off x="6081563" y="6957491"/>
            <a:ext cx="2309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TextBox 184">
            <a:extLst>
              <a:ext uri="{FF2B5EF4-FFF2-40B4-BE49-F238E27FC236}">
                <a16:creationId xmlns:a16="http://schemas.microsoft.com/office/drawing/2014/main" id="{6FB215C6-5513-E143-A1D7-66224C4A8AA9}"/>
              </a:ext>
            </a:extLst>
          </p:cNvPr>
          <p:cNvSpPr txBox="1"/>
          <p:nvPr/>
        </p:nvSpPr>
        <p:spPr>
          <a:xfrm>
            <a:off x="6475399" y="696413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4" name="Chart 1">
            <a:extLst>
              <a:ext uri="{FF2B5EF4-FFF2-40B4-BE49-F238E27FC236}">
                <a16:creationId xmlns:a16="http://schemas.microsoft.com/office/drawing/2014/main" id="{6F19F7F6-8A4E-214F-8E3E-27FB696C24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055406"/>
              </p:ext>
            </p:extLst>
          </p:nvPr>
        </p:nvGraphicFramePr>
        <p:xfrm>
          <a:off x="184598" y="1967856"/>
          <a:ext cx="6650380" cy="23667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465" name="Straight Connector 176">
            <a:extLst>
              <a:ext uri="{FF2B5EF4-FFF2-40B4-BE49-F238E27FC236}">
                <a16:creationId xmlns:a16="http://schemas.microsoft.com/office/drawing/2014/main" id="{7B9580C3-754B-654A-A567-7BB5F529192A}"/>
              </a:ext>
            </a:extLst>
          </p:cNvPr>
          <p:cNvCxnSpPr/>
          <p:nvPr/>
        </p:nvCxnSpPr>
        <p:spPr>
          <a:xfrm>
            <a:off x="921766" y="230406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6" name="Straight Connector 176">
            <a:extLst>
              <a:ext uri="{FF2B5EF4-FFF2-40B4-BE49-F238E27FC236}">
                <a16:creationId xmlns:a16="http://schemas.microsoft.com/office/drawing/2014/main" id="{BA06E8E5-BDD9-7246-8728-CFF50FBF0B5C}"/>
              </a:ext>
            </a:extLst>
          </p:cNvPr>
          <p:cNvCxnSpPr/>
          <p:nvPr/>
        </p:nvCxnSpPr>
        <p:spPr>
          <a:xfrm>
            <a:off x="1338089" y="243641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7" name="Straight Connector 176">
            <a:extLst>
              <a:ext uri="{FF2B5EF4-FFF2-40B4-BE49-F238E27FC236}">
                <a16:creationId xmlns:a16="http://schemas.microsoft.com/office/drawing/2014/main" id="{AA71AC7B-20E0-2649-9FF7-42DB185B3A5F}"/>
              </a:ext>
            </a:extLst>
          </p:cNvPr>
          <p:cNvCxnSpPr/>
          <p:nvPr/>
        </p:nvCxnSpPr>
        <p:spPr>
          <a:xfrm>
            <a:off x="1731523" y="2838895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8" name="Straight Connector 176">
            <a:extLst>
              <a:ext uri="{FF2B5EF4-FFF2-40B4-BE49-F238E27FC236}">
                <a16:creationId xmlns:a16="http://schemas.microsoft.com/office/drawing/2014/main" id="{3675874C-2289-1B46-A34E-D91956195BD7}"/>
              </a:ext>
            </a:extLst>
          </p:cNvPr>
          <p:cNvCxnSpPr/>
          <p:nvPr/>
        </p:nvCxnSpPr>
        <p:spPr>
          <a:xfrm>
            <a:off x="957999" y="6200373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9" name="Straight Connector 176">
            <a:extLst>
              <a:ext uri="{FF2B5EF4-FFF2-40B4-BE49-F238E27FC236}">
                <a16:creationId xmlns:a16="http://schemas.microsoft.com/office/drawing/2014/main" id="{4B03D328-320C-C242-8CF4-57D08AB09333}"/>
              </a:ext>
            </a:extLst>
          </p:cNvPr>
          <p:cNvCxnSpPr/>
          <p:nvPr/>
        </p:nvCxnSpPr>
        <p:spPr>
          <a:xfrm>
            <a:off x="1374322" y="6578157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Connector 176">
            <a:extLst>
              <a:ext uri="{FF2B5EF4-FFF2-40B4-BE49-F238E27FC236}">
                <a16:creationId xmlns:a16="http://schemas.microsoft.com/office/drawing/2014/main" id="{A1884699-9824-5943-A87A-A2CE3EB5295C}"/>
              </a:ext>
            </a:extLst>
          </p:cNvPr>
          <p:cNvCxnSpPr/>
          <p:nvPr/>
        </p:nvCxnSpPr>
        <p:spPr>
          <a:xfrm>
            <a:off x="1758231" y="6044214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1" name="TextBox 184">
            <a:extLst>
              <a:ext uri="{FF2B5EF4-FFF2-40B4-BE49-F238E27FC236}">
                <a16:creationId xmlns:a16="http://schemas.microsoft.com/office/drawing/2014/main" id="{31D5AE0B-CFCF-FB49-A7BF-74B30A0340A9}"/>
              </a:ext>
            </a:extLst>
          </p:cNvPr>
          <p:cNvSpPr txBox="1"/>
          <p:nvPr/>
        </p:nvSpPr>
        <p:spPr>
          <a:xfrm>
            <a:off x="1769281" y="2677949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TextBox 183">
            <a:extLst>
              <a:ext uri="{FF2B5EF4-FFF2-40B4-BE49-F238E27FC236}">
                <a16:creationId xmlns:a16="http://schemas.microsoft.com/office/drawing/2014/main" id="{DFA42640-E2B6-E64A-973D-2862B24F0685}"/>
              </a:ext>
            </a:extLst>
          </p:cNvPr>
          <p:cNvSpPr txBox="1"/>
          <p:nvPr/>
        </p:nvSpPr>
        <p:spPr>
          <a:xfrm>
            <a:off x="1783009" y="6026498"/>
            <a:ext cx="238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73" name="TextBox 184">
            <a:extLst>
              <a:ext uri="{FF2B5EF4-FFF2-40B4-BE49-F238E27FC236}">
                <a16:creationId xmlns:a16="http://schemas.microsoft.com/office/drawing/2014/main" id="{145690C5-4E7C-D643-9927-B00C89E3D87C}"/>
              </a:ext>
            </a:extLst>
          </p:cNvPr>
          <p:cNvSpPr txBox="1"/>
          <p:nvPr/>
        </p:nvSpPr>
        <p:spPr>
          <a:xfrm>
            <a:off x="1012168" y="601779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4" name="37 CuadroTexto">
            <a:extLst>
              <a:ext uri="{FF2B5EF4-FFF2-40B4-BE49-F238E27FC236}">
                <a16:creationId xmlns:a16="http://schemas.microsoft.com/office/drawing/2014/main" id="{8B5503D2-DB8A-6D4F-BD2B-A447119A18DD}"/>
              </a:ext>
            </a:extLst>
          </p:cNvPr>
          <p:cNvSpPr txBox="1"/>
          <p:nvPr/>
        </p:nvSpPr>
        <p:spPr>
          <a:xfrm>
            <a:off x="5950045" y="2131544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PDAC-215</a:t>
            </a:r>
          </a:p>
        </p:txBody>
      </p:sp>
      <p:cxnSp>
        <p:nvCxnSpPr>
          <p:cNvPr id="475" name="Straight Connector 176">
            <a:extLst>
              <a:ext uri="{FF2B5EF4-FFF2-40B4-BE49-F238E27FC236}">
                <a16:creationId xmlns:a16="http://schemas.microsoft.com/office/drawing/2014/main" id="{6A6635DD-7EA1-B04E-AA47-7F2F44A826A5}"/>
              </a:ext>
            </a:extLst>
          </p:cNvPr>
          <p:cNvCxnSpPr/>
          <p:nvPr/>
        </p:nvCxnSpPr>
        <p:spPr>
          <a:xfrm>
            <a:off x="2486742" y="3316799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6" name="Straight Connector 176">
            <a:extLst>
              <a:ext uri="{FF2B5EF4-FFF2-40B4-BE49-F238E27FC236}">
                <a16:creationId xmlns:a16="http://schemas.microsoft.com/office/drawing/2014/main" id="{3EA7F3D1-786C-F04B-95B4-3CC148F9C85F}"/>
              </a:ext>
            </a:extLst>
          </p:cNvPr>
          <p:cNvCxnSpPr/>
          <p:nvPr/>
        </p:nvCxnSpPr>
        <p:spPr>
          <a:xfrm>
            <a:off x="2895028" y="3509168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7" name="Straight Connector 176">
            <a:extLst>
              <a:ext uri="{FF2B5EF4-FFF2-40B4-BE49-F238E27FC236}">
                <a16:creationId xmlns:a16="http://schemas.microsoft.com/office/drawing/2014/main" id="{21E5CADF-9D4A-024D-A785-791ADE3411C8}"/>
              </a:ext>
            </a:extLst>
          </p:cNvPr>
          <p:cNvCxnSpPr/>
          <p:nvPr/>
        </p:nvCxnSpPr>
        <p:spPr>
          <a:xfrm>
            <a:off x="3277913" y="3543056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8" name="Straight Connector 176">
            <a:extLst>
              <a:ext uri="{FF2B5EF4-FFF2-40B4-BE49-F238E27FC236}">
                <a16:creationId xmlns:a16="http://schemas.microsoft.com/office/drawing/2014/main" id="{861E4A98-3FA3-5147-A0F7-5B2BE62EBD51}"/>
              </a:ext>
            </a:extLst>
          </p:cNvPr>
          <p:cNvCxnSpPr/>
          <p:nvPr/>
        </p:nvCxnSpPr>
        <p:spPr>
          <a:xfrm>
            <a:off x="4080459" y="3221160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9" name="Straight Connector 176">
            <a:extLst>
              <a:ext uri="{FF2B5EF4-FFF2-40B4-BE49-F238E27FC236}">
                <a16:creationId xmlns:a16="http://schemas.microsoft.com/office/drawing/2014/main" id="{F8713A66-1123-A64C-B38A-031C72EBD190}"/>
              </a:ext>
            </a:extLst>
          </p:cNvPr>
          <p:cNvCxnSpPr/>
          <p:nvPr/>
        </p:nvCxnSpPr>
        <p:spPr>
          <a:xfrm>
            <a:off x="4457876" y="3468452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0" name="Straight Connector 176">
            <a:extLst>
              <a:ext uri="{FF2B5EF4-FFF2-40B4-BE49-F238E27FC236}">
                <a16:creationId xmlns:a16="http://schemas.microsoft.com/office/drawing/2014/main" id="{0BE04B53-2A1C-E84E-AF4E-ADF4C3AAFE1F}"/>
              </a:ext>
            </a:extLst>
          </p:cNvPr>
          <p:cNvCxnSpPr/>
          <p:nvPr/>
        </p:nvCxnSpPr>
        <p:spPr>
          <a:xfrm>
            <a:off x="4850186" y="3545399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1" name="Straight Connector 176">
            <a:extLst>
              <a:ext uri="{FF2B5EF4-FFF2-40B4-BE49-F238E27FC236}">
                <a16:creationId xmlns:a16="http://schemas.microsoft.com/office/drawing/2014/main" id="{27175CD2-7212-AA4D-8697-51FA359417D3}"/>
              </a:ext>
            </a:extLst>
          </p:cNvPr>
          <p:cNvCxnSpPr/>
          <p:nvPr/>
        </p:nvCxnSpPr>
        <p:spPr>
          <a:xfrm>
            <a:off x="6432849" y="3228207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2" name="Straight Connector 176">
            <a:extLst>
              <a:ext uri="{FF2B5EF4-FFF2-40B4-BE49-F238E27FC236}">
                <a16:creationId xmlns:a16="http://schemas.microsoft.com/office/drawing/2014/main" id="{17DA7432-0332-5F4B-9A75-AB0FF5B87789}"/>
              </a:ext>
            </a:extLst>
          </p:cNvPr>
          <p:cNvCxnSpPr/>
          <p:nvPr/>
        </p:nvCxnSpPr>
        <p:spPr>
          <a:xfrm>
            <a:off x="6022956" y="3514481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3" name="Straight Connector 176">
            <a:extLst>
              <a:ext uri="{FF2B5EF4-FFF2-40B4-BE49-F238E27FC236}">
                <a16:creationId xmlns:a16="http://schemas.microsoft.com/office/drawing/2014/main" id="{93AC600C-1207-BB4A-8E82-2D16FB401A23}"/>
              </a:ext>
            </a:extLst>
          </p:cNvPr>
          <p:cNvCxnSpPr/>
          <p:nvPr/>
        </p:nvCxnSpPr>
        <p:spPr>
          <a:xfrm>
            <a:off x="5636693" y="3267021"/>
            <a:ext cx="2880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4" name="TextBox 184">
            <a:extLst>
              <a:ext uri="{FF2B5EF4-FFF2-40B4-BE49-F238E27FC236}">
                <a16:creationId xmlns:a16="http://schemas.microsoft.com/office/drawing/2014/main" id="{65111EA1-8674-6F40-ACF6-8E6E0654FBC2}"/>
              </a:ext>
            </a:extLst>
          </p:cNvPr>
          <p:cNvSpPr txBox="1"/>
          <p:nvPr/>
        </p:nvSpPr>
        <p:spPr>
          <a:xfrm>
            <a:off x="2521726" y="314818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Box 184">
            <a:extLst>
              <a:ext uri="{FF2B5EF4-FFF2-40B4-BE49-F238E27FC236}">
                <a16:creationId xmlns:a16="http://schemas.microsoft.com/office/drawing/2014/main" id="{3C890AD5-A438-0045-A5AC-A118E01B8CBD}"/>
              </a:ext>
            </a:extLst>
          </p:cNvPr>
          <p:cNvSpPr txBox="1"/>
          <p:nvPr/>
        </p:nvSpPr>
        <p:spPr>
          <a:xfrm>
            <a:off x="2925224" y="3338976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184">
            <a:extLst>
              <a:ext uri="{FF2B5EF4-FFF2-40B4-BE49-F238E27FC236}">
                <a16:creationId xmlns:a16="http://schemas.microsoft.com/office/drawing/2014/main" id="{FC183161-ED1F-8847-8D2B-9B873979547D}"/>
              </a:ext>
            </a:extLst>
          </p:cNvPr>
          <p:cNvSpPr txBox="1"/>
          <p:nvPr/>
        </p:nvSpPr>
        <p:spPr>
          <a:xfrm>
            <a:off x="1381766" y="228421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TextBox 184">
            <a:extLst>
              <a:ext uri="{FF2B5EF4-FFF2-40B4-BE49-F238E27FC236}">
                <a16:creationId xmlns:a16="http://schemas.microsoft.com/office/drawing/2014/main" id="{8A472245-4681-0E44-8DB7-EE73DCF9EEC2}"/>
              </a:ext>
            </a:extLst>
          </p:cNvPr>
          <p:cNvSpPr txBox="1"/>
          <p:nvPr/>
        </p:nvSpPr>
        <p:spPr>
          <a:xfrm>
            <a:off x="972294" y="216891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Box 184">
            <a:extLst>
              <a:ext uri="{FF2B5EF4-FFF2-40B4-BE49-F238E27FC236}">
                <a16:creationId xmlns:a16="http://schemas.microsoft.com/office/drawing/2014/main" id="{12A54468-B0D6-4A49-8141-5178E8D880E1}"/>
              </a:ext>
            </a:extLst>
          </p:cNvPr>
          <p:cNvSpPr txBox="1"/>
          <p:nvPr/>
        </p:nvSpPr>
        <p:spPr>
          <a:xfrm>
            <a:off x="3334987" y="337373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TextBox 184">
            <a:extLst>
              <a:ext uri="{FF2B5EF4-FFF2-40B4-BE49-F238E27FC236}">
                <a16:creationId xmlns:a16="http://schemas.microsoft.com/office/drawing/2014/main" id="{8E3CFB53-BAEB-FF44-BD10-3FEBA1E683F4}"/>
              </a:ext>
            </a:extLst>
          </p:cNvPr>
          <p:cNvSpPr txBox="1"/>
          <p:nvPr/>
        </p:nvSpPr>
        <p:spPr>
          <a:xfrm>
            <a:off x="4134099" y="306602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Box 184">
            <a:extLst>
              <a:ext uri="{FF2B5EF4-FFF2-40B4-BE49-F238E27FC236}">
                <a16:creationId xmlns:a16="http://schemas.microsoft.com/office/drawing/2014/main" id="{D144E84B-B52E-4D41-9478-45ACE177FE28}"/>
              </a:ext>
            </a:extLst>
          </p:cNvPr>
          <p:cNvSpPr txBox="1"/>
          <p:nvPr/>
        </p:nvSpPr>
        <p:spPr>
          <a:xfrm>
            <a:off x="4525212" y="328244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Box 184">
            <a:extLst>
              <a:ext uri="{FF2B5EF4-FFF2-40B4-BE49-F238E27FC236}">
                <a16:creationId xmlns:a16="http://schemas.microsoft.com/office/drawing/2014/main" id="{88170009-4479-BF49-BAF3-B620B98264DF}"/>
              </a:ext>
            </a:extLst>
          </p:cNvPr>
          <p:cNvSpPr txBox="1"/>
          <p:nvPr/>
        </p:nvSpPr>
        <p:spPr>
          <a:xfrm>
            <a:off x="4896997" y="334534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2" name="TextBox 184">
            <a:extLst>
              <a:ext uri="{FF2B5EF4-FFF2-40B4-BE49-F238E27FC236}">
                <a16:creationId xmlns:a16="http://schemas.microsoft.com/office/drawing/2014/main" id="{B8E304BC-0BB7-FA4F-B197-5007ACF5D974}"/>
              </a:ext>
            </a:extLst>
          </p:cNvPr>
          <p:cNvSpPr txBox="1"/>
          <p:nvPr/>
        </p:nvSpPr>
        <p:spPr>
          <a:xfrm>
            <a:off x="5672311" y="308604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3" name="TextBox 184">
            <a:extLst>
              <a:ext uri="{FF2B5EF4-FFF2-40B4-BE49-F238E27FC236}">
                <a16:creationId xmlns:a16="http://schemas.microsoft.com/office/drawing/2014/main" id="{E6E640A8-91EC-0948-B07B-BB55C27C5E9D}"/>
              </a:ext>
            </a:extLst>
          </p:cNvPr>
          <p:cNvSpPr txBox="1"/>
          <p:nvPr/>
        </p:nvSpPr>
        <p:spPr>
          <a:xfrm>
            <a:off x="6466019" y="306931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TextBox 184">
            <a:extLst>
              <a:ext uri="{FF2B5EF4-FFF2-40B4-BE49-F238E27FC236}">
                <a16:creationId xmlns:a16="http://schemas.microsoft.com/office/drawing/2014/main" id="{695F9837-58C4-7948-B8A9-1E3C8F87963C}"/>
              </a:ext>
            </a:extLst>
          </p:cNvPr>
          <p:cNvSpPr txBox="1"/>
          <p:nvPr/>
        </p:nvSpPr>
        <p:spPr>
          <a:xfrm>
            <a:off x="6063740" y="332982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5" name="101 CuadroTexto">
            <a:extLst>
              <a:ext uri="{FF2B5EF4-FFF2-40B4-BE49-F238E27FC236}">
                <a16:creationId xmlns:a16="http://schemas.microsoft.com/office/drawing/2014/main" id="{7A4E01FA-6A67-8344-882C-4294234B3EE3}"/>
              </a:ext>
            </a:extLst>
          </p:cNvPr>
          <p:cNvSpPr txBox="1"/>
          <p:nvPr/>
        </p:nvSpPr>
        <p:spPr>
          <a:xfrm>
            <a:off x="6035536" y="6013923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PDAC-354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5E64D90B-C070-F6BF-812B-DCFE6B7E2EA9}"/>
              </a:ext>
            </a:extLst>
          </p:cNvPr>
          <p:cNvGrpSpPr/>
          <p:nvPr/>
        </p:nvGrpSpPr>
        <p:grpSpPr>
          <a:xfrm>
            <a:off x="2060764" y="1845387"/>
            <a:ext cx="2635677" cy="247905"/>
            <a:chOff x="923093" y="2514282"/>
            <a:chExt cx="2635677" cy="247905"/>
          </a:xfrm>
        </p:grpSpPr>
        <p:sp>
          <p:nvSpPr>
            <p:cNvPr id="3" name="Rectángulo 2">
              <a:extLst>
                <a:ext uri="{FF2B5EF4-FFF2-40B4-BE49-F238E27FC236}">
                  <a16:creationId xmlns:a16="http://schemas.microsoft.com/office/drawing/2014/main" id="{2415653F-7C62-F173-86C2-5E19E159955D}"/>
                </a:ext>
              </a:extLst>
            </p:cNvPr>
            <p:cNvSpPr/>
            <p:nvPr/>
          </p:nvSpPr>
          <p:spPr>
            <a:xfrm>
              <a:off x="1457892" y="2601394"/>
              <a:ext cx="72000" cy="72000"/>
            </a:xfrm>
            <a:prstGeom prst="rect">
              <a:avLst/>
            </a:prstGeom>
            <a:solidFill>
              <a:srgbClr val="595959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" name="Rectángulo 3">
              <a:extLst>
                <a:ext uri="{FF2B5EF4-FFF2-40B4-BE49-F238E27FC236}">
                  <a16:creationId xmlns:a16="http://schemas.microsoft.com/office/drawing/2014/main" id="{CEB0E945-C580-CC79-0A37-FEA132A4EE14}"/>
                </a:ext>
              </a:extLst>
            </p:cNvPr>
            <p:cNvSpPr/>
            <p:nvPr/>
          </p:nvSpPr>
          <p:spPr>
            <a:xfrm>
              <a:off x="1982074" y="2601394"/>
              <a:ext cx="72000" cy="72000"/>
            </a:xfrm>
            <a:prstGeom prst="rect">
              <a:avLst/>
            </a:prstGeom>
            <a:solidFill>
              <a:srgbClr val="A6A6A6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5" name="Rectángulo 4">
              <a:extLst>
                <a:ext uri="{FF2B5EF4-FFF2-40B4-BE49-F238E27FC236}">
                  <a16:creationId xmlns:a16="http://schemas.microsoft.com/office/drawing/2014/main" id="{FD583B0E-DED0-5FFB-800B-BD2FCC311A4D}"/>
                </a:ext>
              </a:extLst>
            </p:cNvPr>
            <p:cNvSpPr/>
            <p:nvPr/>
          </p:nvSpPr>
          <p:spPr>
            <a:xfrm>
              <a:off x="2531957" y="2601394"/>
              <a:ext cx="72000" cy="7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rgbClr val="D9D9D9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" name="Rectángulo 5">
              <a:extLst>
                <a:ext uri="{FF2B5EF4-FFF2-40B4-BE49-F238E27FC236}">
                  <a16:creationId xmlns:a16="http://schemas.microsoft.com/office/drawing/2014/main" id="{0CDA1937-5141-8D2F-1345-98A4673D1743}"/>
                </a:ext>
              </a:extLst>
            </p:cNvPr>
            <p:cNvSpPr/>
            <p:nvPr/>
          </p:nvSpPr>
          <p:spPr>
            <a:xfrm>
              <a:off x="3133721" y="2601394"/>
              <a:ext cx="72000" cy="7200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D0B4E531-D654-9D76-6BA0-0612C6E0F389}"/>
                </a:ext>
              </a:extLst>
            </p:cNvPr>
            <p:cNvSpPr txBox="1"/>
            <p:nvPr/>
          </p:nvSpPr>
          <p:spPr>
            <a:xfrm>
              <a:off x="1455449" y="2515966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NAI1</a:t>
              </a:r>
            </a:p>
          </p:txBody>
        </p:sp>
        <p:sp>
          <p:nvSpPr>
            <p:cNvPr id="8" name="Rectángulo 7">
              <a:extLst>
                <a:ext uri="{FF2B5EF4-FFF2-40B4-BE49-F238E27FC236}">
                  <a16:creationId xmlns:a16="http://schemas.microsoft.com/office/drawing/2014/main" id="{427173E5-D921-DC38-A605-9AFE7CBC546F}"/>
                </a:ext>
              </a:extLst>
            </p:cNvPr>
            <p:cNvSpPr/>
            <p:nvPr/>
          </p:nvSpPr>
          <p:spPr>
            <a:xfrm>
              <a:off x="923093" y="2601394"/>
              <a:ext cx="72000" cy="7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C8FA0EA5-3188-B785-CBF6-70AA9106B8E9}"/>
                </a:ext>
              </a:extLst>
            </p:cNvPr>
            <p:cNvSpPr txBox="1"/>
            <p:nvPr/>
          </p:nvSpPr>
          <p:spPr>
            <a:xfrm>
              <a:off x="943770" y="2515966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EB1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32570420-A26C-4056-DB32-8CCE20E5AB98}"/>
                </a:ext>
              </a:extLst>
            </p:cNvPr>
            <p:cNvSpPr txBox="1"/>
            <p:nvPr/>
          </p:nvSpPr>
          <p:spPr>
            <a:xfrm>
              <a:off x="1983319" y="2514283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NAI2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AAA76B99-8732-9463-9BE7-DB5DCEBEFB71}"/>
                </a:ext>
              </a:extLst>
            </p:cNvPr>
            <p:cNvSpPr txBox="1"/>
            <p:nvPr/>
          </p:nvSpPr>
          <p:spPr>
            <a:xfrm>
              <a:off x="2557848" y="2514283"/>
              <a:ext cx="5966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OXL2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A68B23F9-EFE8-77F7-D9D3-70364D98BF07}"/>
                </a:ext>
              </a:extLst>
            </p:cNvPr>
            <p:cNvSpPr txBox="1"/>
            <p:nvPr/>
          </p:nvSpPr>
          <p:spPr>
            <a:xfrm>
              <a:off x="3146478" y="2514282"/>
              <a:ext cx="4122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VIM</a:t>
              </a:r>
            </a:p>
          </p:txBody>
        </p:sp>
      </p:grpSp>
      <p:sp>
        <p:nvSpPr>
          <p:cNvPr id="13" name="TextBox 3">
            <a:extLst>
              <a:ext uri="{FF2B5EF4-FFF2-40B4-BE49-F238E27FC236}">
                <a16:creationId xmlns:a16="http://schemas.microsoft.com/office/drawing/2014/main" id="{70A1B2D8-8B1B-2534-24BE-4437C73FA128}"/>
              </a:ext>
            </a:extLst>
          </p:cNvPr>
          <p:cNvSpPr txBox="1"/>
          <p:nvPr/>
        </p:nvSpPr>
        <p:spPr>
          <a:xfrm>
            <a:off x="-1782" y="-8323"/>
            <a:ext cx="684275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9, related to Figure 4</a:t>
            </a:r>
          </a:p>
          <a:p>
            <a:pPr algn="just"/>
            <a:endParaRPr lang="en-GB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Knockdown of PPAR-𝛅 inhibits the expression changes induced by MCM or etomoxir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Changes in expression of EMT-related genes in PDAC-215 (upper panel), 253 (middle panel), and 354 (lower panel) cells transduced with inducible lentiviral vectors expressing either a non-targeting shRNA (NT) or three different shRNA against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PARD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sh#1, sh#2, sh#3). Cells were pre-treated with doxycycline for 24h to induce shRNA expression and subsequently incubated with MCM, 20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etomoxir (Eto) or 5</a:t>
            </a:r>
            <a:r>
              <a:rPr lang="el-GR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L-165 (n=5-7). Data are represented as the fold change to NT control condition, </a:t>
            </a:r>
            <a:r>
              <a:rPr lang="en-US" sz="100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depicted as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ean ± SEM and analyzed using t-test or one-way ANOVA. * p&lt;0.05, ** p&lt;0.01, *** p&lt;0.001 vs control (Ctrl) and # p&lt;0.05, ## p&lt;0.01, ### p&lt;0.001 vs NT.</a:t>
            </a:r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792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3</Words>
  <Application>Microsoft Office PowerPoint</Application>
  <PresentationFormat>Presentación en pantalla (4:3)</PresentationFormat>
  <Paragraphs>6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tricia sancho</cp:lastModifiedBy>
  <cp:revision>960</cp:revision>
  <cp:lastPrinted>2020-07-03T05:57:45Z</cp:lastPrinted>
  <dcterms:created xsi:type="dcterms:W3CDTF">2016-12-14T11:07:19Z</dcterms:created>
  <dcterms:modified xsi:type="dcterms:W3CDTF">2025-07-11T17:16:45Z</dcterms:modified>
</cp:coreProperties>
</file>